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06" r:id="rId2"/>
    <p:sldId id="312" r:id="rId3"/>
  </p:sldIdLst>
  <p:sldSz cx="9906000" cy="6858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00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ADD0236-5E26-4F1B-BEDB-CD5B4FA43E5A}" v="59" dt="2019-05-01T14:39:47.08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40" y="4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8511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5223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468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2154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9011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2182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494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966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865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5839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9713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E217A-D2D1-4EBF-94B2-ECB9A2ECCACF}" type="datetimeFigureOut">
              <a:rPr lang="en-GB" smtClean="0"/>
              <a:t>13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176B1-820F-4495-9804-0176E0A99C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389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4" name="Picture 163">
            <a:extLst>
              <a:ext uri="{FF2B5EF4-FFF2-40B4-BE49-F238E27FC236}">
                <a16:creationId xmlns:a16="http://schemas.microsoft.com/office/drawing/2014/main" id="{81D3B958-D67A-4133-9C74-C2E02D45E8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2863" y="2678007"/>
            <a:ext cx="1713354" cy="1990057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1CE4D496-61AB-4F58-BE65-D2D9F4644F4A}"/>
              </a:ext>
            </a:extLst>
          </p:cNvPr>
          <p:cNvGrpSpPr/>
          <p:nvPr/>
        </p:nvGrpSpPr>
        <p:grpSpPr>
          <a:xfrm>
            <a:off x="235936" y="70460"/>
            <a:ext cx="4675665" cy="2277497"/>
            <a:chOff x="224449" y="1072283"/>
            <a:chExt cx="4675665" cy="2277497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EC850BA-987E-41AA-9921-29437198AA0B}"/>
                </a:ext>
              </a:extLst>
            </p:cNvPr>
            <p:cNvSpPr txBox="1"/>
            <p:nvPr/>
          </p:nvSpPr>
          <p:spPr>
            <a:xfrm>
              <a:off x="596951" y="1968638"/>
              <a:ext cx="4925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D342FEC-D254-4D34-954E-915EF75F5F9A}"/>
                </a:ext>
              </a:extLst>
            </p:cNvPr>
            <p:cNvSpPr txBox="1"/>
            <p:nvPr/>
          </p:nvSpPr>
          <p:spPr>
            <a:xfrm>
              <a:off x="657967" y="2876733"/>
              <a:ext cx="8289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grpSp>
          <p:nvGrpSpPr>
            <p:cNvPr id="17" name="Group 49">
              <a:extLst>
                <a:ext uri="{FF2B5EF4-FFF2-40B4-BE49-F238E27FC236}">
                  <a16:creationId xmlns:a16="http://schemas.microsoft.com/office/drawing/2014/main" id="{26DF6B43-7E31-4ABD-B731-3144D84CE6F7}"/>
                </a:ext>
              </a:extLst>
            </p:cNvPr>
            <p:cNvGrpSpPr/>
            <p:nvPr/>
          </p:nvGrpSpPr>
          <p:grpSpPr>
            <a:xfrm flipH="1">
              <a:off x="1399334" y="2384152"/>
              <a:ext cx="1108196" cy="585502"/>
              <a:chOff x="5495255" y="1518900"/>
              <a:chExt cx="1345965" cy="944674"/>
            </a:xfrm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F5776B15-C05F-49A8-9CA1-716FCCFD264B}"/>
                  </a:ext>
                </a:extLst>
              </p:cNvPr>
              <p:cNvCxnSpPr/>
              <p:nvPr/>
            </p:nvCxnSpPr>
            <p:spPr>
              <a:xfrm>
                <a:off x="6154538" y="1518900"/>
                <a:ext cx="0" cy="43262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1812AA1E-602C-4255-AB8E-F31577B24713}"/>
                  </a:ext>
                </a:extLst>
              </p:cNvPr>
              <p:cNvCxnSpPr/>
              <p:nvPr/>
            </p:nvCxnSpPr>
            <p:spPr>
              <a:xfrm>
                <a:off x="5794498" y="2016653"/>
                <a:ext cx="296416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1392ABEF-F58F-42D7-A20A-151E0647919C}"/>
                  </a:ext>
                </a:extLst>
              </p:cNvPr>
              <p:cNvSpPr txBox="1"/>
              <p:nvPr/>
            </p:nvSpPr>
            <p:spPr>
              <a:xfrm>
                <a:off x="6042101" y="1537167"/>
                <a:ext cx="799119" cy="446922"/>
              </a:xfrm>
              <a:prstGeom prst="rect">
                <a:avLst/>
              </a:prstGeom>
              <a:noFill/>
              <a:ln w="25400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 </a:t>
                </a:r>
                <a:r>
                  <a:rPr lang="en-GB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N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57">
                <a:extLst>
                  <a:ext uri="{FF2B5EF4-FFF2-40B4-BE49-F238E27FC236}">
                    <a16:creationId xmlns:a16="http://schemas.microsoft.com/office/drawing/2014/main" id="{1102840F-DCF2-4415-9327-A521BDFFEB66}"/>
                  </a:ext>
                </a:extLst>
              </p:cNvPr>
              <p:cNvSpPr txBox="1"/>
              <p:nvPr/>
            </p:nvSpPr>
            <p:spPr>
              <a:xfrm>
                <a:off x="5495255" y="2016652"/>
                <a:ext cx="848495" cy="446922"/>
              </a:xfrm>
              <a:prstGeom prst="rect">
                <a:avLst/>
              </a:prstGeom>
              <a:noFill/>
              <a:ln w="25400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 min</a:t>
                </a:r>
              </a:p>
            </p:txBody>
          </p:sp>
        </p:grpSp>
        <p:pic>
          <p:nvPicPr>
            <p:cNvPr id="22" name="Picture 4">
              <a:extLst>
                <a:ext uri="{FF2B5EF4-FFF2-40B4-BE49-F238E27FC236}">
                  <a16:creationId xmlns:a16="http://schemas.microsoft.com/office/drawing/2014/main" id="{AA3C940F-D642-4867-B149-421ED93314F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5374" y="1350306"/>
              <a:ext cx="3924740" cy="11000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2" name="Group 13">
              <a:extLst>
                <a:ext uri="{FF2B5EF4-FFF2-40B4-BE49-F238E27FC236}">
                  <a16:creationId xmlns:a16="http://schemas.microsoft.com/office/drawing/2014/main" id="{72CCFC5E-2A42-4A21-B63B-1FC36F09D7BF}"/>
                </a:ext>
              </a:extLst>
            </p:cNvPr>
            <p:cNvGrpSpPr/>
            <p:nvPr/>
          </p:nvGrpSpPr>
          <p:grpSpPr>
            <a:xfrm>
              <a:off x="994254" y="2202338"/>
              <a:ext cx="3847550" cy="1147442"/>
              <a:chOff x="993301" y="1493609"/>
              <a:chExt cx="6261100" cy="1953331"/>
            </a:xfrm>
          </p:grpSpPr>
          <p:pic>
            <p:nvPicPr>
              <p:cNvPr id="43" name="Picture 8">
                <a:extLst>
                  <a:ext uri="{FF2B5EF4-FFF2-40B4-BE49-F238E27FC236}">
                    <a16:creationId xmlns:a16="http://schemas.microsoft.com/office/drawing/2014/main" id="{4B61C983-6043-4DA1-B7A1-71E6562D0B8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3301" y="1757839"/>
                <a:ext cx="6261100" cy="16891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4" name="Rectangle 12">
                <a:extLst>
                  <a:ext uri="{FF2B5EF4-FFF2-40B4-BE49-F238E27FC236}">
                    <a16:creationId xmlns:a16="http://schemas.microsoft.com/office/drawing/2014/main" id="{08D03BA7-707C-49D6-9BCA-EDA464BBF45E}"/>
                  </a:ext>
                </a:extLst>
              </p:cNvPr>
              <p:cNvSpPr/>
              <p:nvPr/>
            </p:nvSpPr>
            <p:spPr>
              <a:xfrm>
                <a:off x="6464922" y="1493609"/>
                <a:ext cx="299801" cy="26897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grpSp>
          <p:nvGrpSpPr>
            <p:cNvPr id="45" name="Group 94">
              <a:extLst>
                <a:ext uri="{FF2B5EF4-FFF2-40B4-BE49-F238E27FC236}">
                  <a16:creationId xmlns:a16="http://schemas.microsoft.com/office/drawing/2014/main" id="{30BFB58B-81D5-4516-BF7F-0932F90207F0}"/>
                </a:ext>
              </a:extLst>
            </p:cNvPr>
            <p:cNvGrpSpPr/>
            <p:nvPr/>
          </p:nvGrpSpPr>
          <p:grpSpPr>
            <a:xfrm>
              <a:off x="645118" y="1072283"/>
              <a:ext cx="3924955" cy="663681"/>
              <a:chOff x="884574" y="-161329"/>
              <a:chExt cx="4040653" cy="1070807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1F8564E4-2CF6-43A9-B85F-74B040DB945B}"/>
                  </a:ext>
                </a:extLst>
              </p:cNvPr>
              <p:cNvSpPr txBox="1"/>
              <p:nvPr/>
            </p:nvSpPr>
            <p:spPr>
              <a:xfrm>
                <a:off x="1357326" y="-107840"/>
                <a:ext cx="673402" cy="744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ash </a:t>
                </a:r>
              </a:p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</a:t>
                </a:r>
              </a:p>
            </p:txBody>
          </p:sp>
          <p:cxnSp>
            <p:nvCxnSpPr>
              <p:cNvPr id="47" name="Straight Arrow Connector 46">
                <a:extLst>
                  <a:ext uri="{FF2B5EF4-FFF2-40B4-BE49-F238E27FC236}">
                    <a16:creationId xmlns:a16="http://schemas.microsoft.com/office/drawing/2014/main" id="{93363076-B400-4ED6-9A77-CD89458962CA}"/>
                  </a:ext>
                </a:extLst>
              </p:cNvPr>
              <p:cNvCxnSpPr/>
              <p:nvPr/>
            </p:nvCxnSpPr>
            <p:spPr>
              <a:xfrm>
                <a:off x="1244002" y="550713"/>
                <a:ext cx="0" cy="23404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5D7C61B5-7638-47BA-915D-CB552CFF65F0}"/>
                  </a:ext>
                </a:extLst>
              </p:cNvPr>
              <p:cNvCxnSpPr/>
              <p:nvPr/>
            </p:nvCxnSpPr>
            <p:spPr>
              <a:xfrm>
                <a:off x="2399991" y="558740"/>
                <a:ext cx="0" cy="23404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>
                <a:extLst>
                  <a:ext uri="{FF2B5EF4-FFF2-40B4-BE49-F238E27FC236}">
                    <a16:creationId xmlns:a16="http://schemas.microsoft.com/office/drawing/2014/main" id="{0DC2CE9A-CD2C-44F3-8EA4-CDAC33572E32}"/>
                  </a:ext>
                </a:extLst>
              </p:cNvPr>
              <p:cNvCxnSpPr/>
              <p:nvPr/>
            </p:nvCxnSpPr>
            <p:spPr>
              <a:xfrm>
                <a:off x="3408103" y="558740"/>
                <a:ext cx="0" cy="23404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>
                <a:extLst>
                  <a:ext uri="{FF2B5EF4-FFF2-40B4-BE49-F238E27FC236}">
                    <a16:creationId xmlns:a16="http://schemas.microsoft.com/office/drawing/2014/main" id="{4E83D29F-0052-4403-9CD3-BC1A4EDB291A}"/>
                  </a:ext>
                </a:extLst>
              </p:cNvPr>
              <p:cNvCxnSpPr/>
              <p:nvPr/>
            </p:nvCxnSpPr>
            <p:spPr>
              <a:xfrm>
                <a:off x="4468786" y="550713"/>
                <a:ext cx="0" cy="23404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BC47BC6-8C23-42E3-9BE0-0AD73A419C55}"/>
                  </a:ext>
                </a:extLst>
              </p:cNvPr>
              <p:cNvSpPr txBox="1"/>
              <p:nvPr/>
            </p:nvSpPr>
            <p:spPr>
              <a:xfrm>
                <a:off x="884574" y="-133336"/>
                <a:ext cx="657617" cy="10428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mM </a:t>
                </a:r>
              </a:p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Cl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0D731ED-EC83-4B6B-841D-865B41FC26B9}"/>
                  </a:ext>
                </a:extLst>
              </p:cNvPr>
              <p:cNvSpPr txBox="1"/>
              <p:nvPr/>
            </p:nvSpPr>
            <p:spPr>
              <a:xfrm>
                <a:off x="3091410" y="-161329"/>
                <a:ext cx="642672" cy="7448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µM</a:t>
                </a:r>
              </a:p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D91A9EF6-6018-44A0-B469-E4E92A27779B}"/>
                  </a:ext>
                </a:extLst>
              </p:cNvPr>
              <p:cNvSpPr txBox="1"/>
              <p:nvPr/>
            </p:nvSpPr>
            <p:spPr>
              <a:xfrm>
                <a:off x="3993753" y="-125908"/>
                <a:ext cx="931474" cy="744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µM</a:t>
                </a:r>
              </a:p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</a:t>
                </a:r>
              </a:p>
            </p:txBody>
          </p:sp>
          <p:cxnSp>
            <p:nvCxnSpPr>
              <p:cNvPr id="54" name="Straight Arrow Connector 53">
                <a:extLst>
                  <a:ext uri="{FF2B5EF4-FFF2-40B4-BE49-F238E27FC236}">
                    <a16:creationId xmlns:a16="http://schemas.microsoft.com/office/drawing/2014/main" id="{61E32779-71D3-460F-9734-21BF2ECA609D}"/>
                  </a:ext>
                </a:extLst>
              </p:cNvPr>
              <p:cNvCxnSpPr/>
              <p:nvPr/>
            </p:nvCxnSpPr>
            <p:spPr>
              <a:xfrm>
                <a:off x="1679911" y="550713"/>
                <a:ext cx="0" cy="23404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19B646C-E0FC-427D-829A-E346DF3E43F6}"/>
                </a:ext>
              </a:extLst>
            </p:cNvPr>
            <p:cNvSpPr txBox="1"/>
            <p:nvPr/>
          </p:nvSpPr>
          <p:spPr>
            <a:xfrm>
              <a:off x="1762697" y="1106907"/>
              <a:ext cx="7241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mM </a:t>
              </a:r>
            </a:p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Cl</a:t>
              </a:r>
            </a:p>
          </p:txBody>
        </p:sp>
        <p:sp>
          <p:nvSpPr>
            <p:cNvPr id="105" name="Text Box 19">
              <a:extLst>
                <a:ext uri="{FF2B5EF4-FFF2-40B4-BE49-F238E27FC236}">
                  <a16:creationId xmlns:a16="http://schemas.microsoft.com/office/drawing/2014/main" id="{33E251BE-4E30-4AD1-9E1A-EDD975BD16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449" y="1428600"/>
              <a:ext cx="32282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b="1" dirty="0"/>
                <a:t>A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3864B0D-7582-44CD-8F6A-3AF8BFE6DC47}"/>
              </a:ext>
            </a:extLst>
          </p:cNvPr>
          <p:cNvGrpSpPr/>
          <p:nvPr/>
        </p:nvGrpSpPr>
        <p:grpSpPr>
          <a:xfrm>
            <a:off x="5038335" y="187942"/>
            <a:ext cx="4405446" cy="2099295"/>
            <a:chOff x="3366391" y="3155950"/>
            <a:chExt cx="2815960" cy="1920132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4FD0650-60EA-465D-8D73-17077C10FBA6}"/>
                </a:ext>
              </a:extLst>
            </p:cNvPr>
            <p:cNvSpPr txBox="1"/>
            <p:nvPr/>
          </p:nvSpPr>
          <p:spPr>
            <a:xfrm>
              <a:off x="5344841" y="4705201"/>
              <a:ext cx="729081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B8A1DC4-F6D3-4C55-B795-C5371A0A0AE4}"/>
                </a:ext>
              </a:extLst>
            </p:cNvPr>
            <p:cNvSpPr txBox="1"/>
            <p:nvPr/>
          </p:nvSpPr>
          <p:spPr>
            <a:xfrm>
              <a:off x="5810766" y="4711407"/>
              <a:ext cx="337618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6625EBA5-E1A9-49EE-81CE-207CFC5FDF41}"/>
                </a:ext>
              </a:extLst>
            </p:cNvPr>
            <p:cNvCxnSpPr/>
            <p:nvPr/>
          </p:nvCxnSpPr>
          <p:spPr>
            <a:xfrm>
              <a:off x="5523134" y="3608476"/>
              <a:ext cx="360836" cy="0"/>
            </a:xfrm>
            <a:prstGeom prst="line">
              <a:avLst/>
            </a:prstGeom>
            <a:ln w="25400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F4C184A-587E-4607-A3C9-F87EB1F9AFF0}"/>
                </a:ext>
              </a:extLst>
            </p:cNvPr>
            <p:cNvSpPr txBox="1"/>
            <p:nvPr/>
          </p:nvSpPr>
          <p:spPr>
            <a:xfrm>
              <a:off x="5499291" y="3426696"/>
              <a:ext cx="364541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52F8529-C724-4321-848C-739D37538885}"/>
                </a:ext>
              </a:extLst>
            </p:cNvPr>
            <p:cNvSpPr txBox="1"/>
            <p:nvPr/>
          </p:nvSpPr>
          <p:spPr>
            <a:xfrm>
              <a:off x="5084096" y="3680259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16F91F2-38E7-4D49-81EB-1BFA04FB35BE}"/>
                </a:ext>
              </a:extLst>
            </p:cNvPr>
            <p:cNvSpPr txBox="1"/>
            <p:nvPr/>
          </p:nvSpPr>
          <p:spPr>
            <a:xfrm>
              <a:off x="5112452" y="3912750"/>
              <a:ext cx="214671" cy="4222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CCFD1A1-3B5A-4829-86B5-D72BA2DE0CD5}"/>
                </a:ext>
              </a:extLst>
            </p:cNvPr>
            <p:cNvSpPr txBox="1"/>
            <p:nvPr/>
          </p:nvSpPr>
          <p:spPr>
            <a:xfrm>
              <a:off x="5084096" y="4138183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F79F30D-169B-4EA8-9176-E2D391216DE6}"/>
                </a:ext>
              </a:extLst>
            </p:cNvPr>
            <p:cNvSpPr txBox="1"/>
            <p:nvPr/>
          </p:nvSpPr>
          <p:spPr>
            <a:xfrm>
              <a:off x="5086353" y="4358299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1507CDB-B37D-499E-AFC3-A67250E0EB23}"/>
                </a:ext>
              </a:extLst>
            </p:cNvPr>
            <p:cNvSpPr txBox="1"/>
            <p:nvPr/>
          </p:nvSpPr>
          <p:spPr>
            <a:xfrm>
              <a:off x="5088609" y="4582854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1A3F08B-A2C4-4B38-A31F-5736FCD0BA43}"/>
                </a:ext>
              </a:extLst>
            </p:cNvPr>
            <p:cNvSpPr txBox="1"/>
            <p:nvPr/>
          </p:nvSpPr>
          <p:spPr>
            <a:xfrm>
              <a:off x="5088609" y="3460993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B200E5C-4AC6-4409-BB03-1E0CE00BC1D2}"/>
                </a:ext>
              </a:extLst>
            </p:cNvPr>
            <p:cNvSpPr txBox="1"/>
            <p:nvPr/>
          </p:nvSpPr>
          <p:spPr>
            <a:xfrm rot="16200000">
              <a:off x="4093663" y="3968468"/>
              <a:ext cx="1920132" cy="295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O-induced </a:t>
              </a:r>
            </a:p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e-contracted Tone (</a:t>
              </a:r>
              <a:r>
                <a:rPr lang="en-GB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N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4375E7D-E578-4A37-88D1-6B7CFD10A3E5}"/>
                </a:ext>
              </a:extLst>
            </p:cNvPr>
            <p:cNvSpPr txBox="1"/>
            <p:nvPr/>
          </p:nvSpPr>
          <p:spPr>
            <a:xfrm>
              <a:off x="4367907" y="4709533"/>
              <a:ext cx="304082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7B9BCEB-03C0-4F97-ADC5-4D5DFF8FFCA0}"/>
                </a:ext>
              </a:extLst>
            </p:cNvPr>
            <p:cNvSpPr txBox="1"/>
            <p:nvPr/>
          </p:nvSpPr>
          <p:spPr>
            <a:xfrm>
              <a:off x="3944063" y="4724578"/>
              <a:ext cx="277896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BE5BDDAE-8240-4C00-AC9B-BDFBC41DD3C2}"/>
                </a:ext>
              </a:extLst>
            </p:cNvPr>
            <p:cNvCxnSpPr/>
            <p:nvPr/>
          </p:nvCxnSpPr>
          <p:spPr>
            <a:xfrm>
              <a:off x="4074265" y="4034520"/>
              <a:ext cx="360836" cy="0"/>
            </a:xfrm>
            <a:prstGeom prst="line">
              <a:avLst/>
            </a:prstGeom>
            <a:ln w="25400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B57F8FE-08D8-41A9-A7B3-D1F60EE99CC3}"/>
                </a:ext>
              </a:extLst>
            </p:cNvPr>
            <p:cNvSpPr txBox="1"/>
            <p:nvPr/>
          </p:nvSpPr>
          <p:spPr>
            <a:xfrm>
              <a:off x="4084414" y="3831998"/>
              <a:ext cx="364541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42243BA-DB3E-48F5-A5F3-9A73511DA653}"/>
                </a:ext>
              </a:extLst>
            </p:cNvPr>
            <p:cNvSpPr txBox="1"/>
            <p:nvPr/>
          </p:nvSpPr>
          <p:spPr>
            <a:xfrm>
              <a:off x="3669219" y="3699636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6F1AE52-B9F7-469B-8A28-8581894ADC8B}"/>
                </a:ext>
              </a:extLst>
            </p:cNvPr>
            <p:cNvSpPr txBox="1"/>
            <p:nvPr/>
          </p:nvSpPr>
          <p:spPr>
            <a:xfrm>
              <a:off x="3697575" y="3932127"/>
              <a:ext cx="214671" cy="4222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3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A972A73-4A7A-47F5-BA2F-CA2698E3F5C9}"/>
                </a:ext>
              </a:extLst>
            </p:cNvPr>
            <p:cNvSpPr txBox="1"/>
            <p:nvPr/>
          </p:nvSpPr>
          <p:spPr>
            <a:xfrm>
              <a:off x="3669219" y="4157560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0D1B3C7-6F78-49D7-B759-E5FC1FD4DA02}"/>
                </a:ext>
              </a:extLst>
            </p:cNvPr>
            <p:cNvSpPr txBox="1"/>
            <p:nvPr/>
          </p:nvSpPr>
          <p:spPr>
            <a:xfrm>
              <a:off x="3671476" y="4377676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FE0DEB7-EC00-43E6-9010-9EA6F6F606F0}"/>
                </a:ext>
              </a:extLst>
            </p:cNvPr>
            <p:cNvSpPr txBox="1"/>
            <p:nvPr/>
          </p:nvSpPr>
          <p:spPr>
            <a:xfrm>
              <a:off x="3673732" y="4602231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28E30FE-9B9A-45B2-BF00-942786C3D4FD}"/>
                </a:ext>
              </a:extLst>
            </p:cNvPr>
            <p:cNvSpPr txBox="1"/>
            <p:nvPr/>
          </p:nvSpPr>
          <p:spPr>
            <a:xfrm>
              <a:off x="3673732" y="3480371"/>
              <a:ext cx="238514" cy="253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998F667-9E5D-4B6B-BC2B-8A173E7FA3EE}"/>
                </a:ext>
              </a:extLst>
            </p:cNvPr>
            <p:cNvSpPr txBox="1"/>
            <p:nvPr/>
          </p:nvSpPr>
          <p:spPr>
            <a:xfrm rot="16200000">
              <a:off x="2702309" y="3943973"/>
              <a:ext cx="1890774" cy="354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Cl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induced</a:t>
              </a:r>
            </a:p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pre-contracted tone (mN)</a:t>
              </a:r>
            </a:p>
          </p:txBody>
        </p:sp>
        <p:sp>
          <p:nvSpPr>
            <p:cNvPr id="106" name="Text Box 19">
              <a:extLst>
                <a:ext uri="{FF2B5EF4-FFF2-40B4-BE49-F238E27FC236}">
                  <a16:creationId xmlns:a16="http://schemas.microsoft.com/office/drawing/2014/main" id="{04F85F8C-7CD2-4A3F-BEF1-C8C636DBA0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6391" y="3162573"/>
              <a:ext cx="226969" cy="2533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b="1" dirty="0"/>
                <a:t>B</a:t>
              </a:r>
            </a:p>
          </p:txBody>
        </p:sp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26655735-6417-40DE-B2A1-37FB4F828EF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11192" y="3402079"/>
              <a:ext cx="949915" cy="1371719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59108ABD-BDE7-465B-A8DE-9A4E322F747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229006" y="3393036"/>
              <a:ext cx="953345" cy="1371719"/>
            </a:xfrm>
            <a:prstGeom prst="rect">
              <a:avLst/>
            </a:prstGeom>
          </p:spPr>
        </p:pic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F9CB99E2-A087-4FB0-8B81-6A83EA9CF9F1}"/>
              </a:ext>
            </a:extLst>
          </p:cNvPr>
          <p:cNvGrpSpPr/>
          <p:nvPr/>
        </p:nvGrpSpPr>
        <p:grpSpPr>
          <a:xfrm>
            <a:off x="407822" y="2722389"/>
            <a:ext cx="4342924" cy="1809860"/>
            <a:chOff x="-1239585" y="6063605"/>
            <a:chExt cx="6086599" cy="2817549"/>
          </a:xfrm>
        </p:grpSpPr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68FE462B-8928-454B-B9BA-2E7962766C7C}"/>
                </a:ext>
              </a:extLst>
            </p:cNvPr>
            <p:cNvGrpSpPr/>
            <p:nvPr/>
          </p:nvGrpSpPr>
          <p:grpSpPr>
            <a:xfrm>
              <a:off x="-1239585" y="6063605"/>
              <a:ext cx="6086599" cy="2817549"/>
              <a:chOff x="-538265" y="3819226"/>
              <a:chExt cx="6647128" cy="2429866"/>
            </a:xfrm>
          </p:grpSpPr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75147B1A-9AA9-46E5-806C-A3D2B73DEBE5}"/>
                  </a:ext>
                </a:extLst>
              </p:cNvPr>
              <p:cNvSpPr txBox="1"/>
              <p:nvPr/>
            </p:nvSpPr>
            <p:spPr>
              <a:xfrm>
                <a:off x="1530727" y="3819226"/>
                <a:ext cx="1889650" cy="4670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µM SNP</a:t>
                </a:r>
              </a:p>
            </p:txBody>
          </p:sp>
          <p:cxnSp>
            <p:nvCxnSpPr>
              <p:cNvPr id="135" name="Straight Arrow Connector 36">
                <a:extLst>
                  <a:ext uri="{FF2B5EF4-FFF2-40B4-BE49-F238E27FC236}">
                    <a16:creationId xmlns:a16="http://schemas.microsoft.com/office/drawing/2014/main" id="{949D658B-1D3A-4CBB-B5CC-6D9AAC5BFF50}"/>
                  </a:ext>
                </a:extLst>
              </p:cNvPr>
              <p:cNvCxnSpPr/>
              <p:nvPr/>
            </p:nvCxnSpPr>
            <p:spPr>
              <a:xfrm>
                <a:off x="2048548" y="4157092"/>
                <a:ext cx="0" cy="23593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7C7D2ADC-74E3-4823-8523-D6C9D49151C4}"/>
                  </a:ext>
                </a:extLst>
              </p:cNvPr>
              <p:cNvSpPr txBox="1"/>
              <p:nvPr/>
            </p:nvSpPr>
            <p:spPr>
              <a:xfrm>
                <a:off x="1522832" y="5305279"/>
                <a:ext cx="1296145" cy="4670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138" name="Straight Arrow Connector 137">
                <a:extLst>
                  <a:ext uri="{FF2B5EF4-FFF2-40B4-BE49-F238E27FC236}">
                    <a16:creationId xmlns:a16="http://schemas.microsoft.com/office/drawing/2014/main" id="{D5675923-2289-4DF2-89B6-7E17F1A84A96}"/>
                  </a:ext>
                </a:extLst>
              </p:cNvPr>
              <p:cNvCxnSpPr/>
              <p:nvPr/>
            </p:nvCxnSpPr>
            <p:spPr>
              <a:xfrm flipV="1">
                <a:off x="1112444" y="5692784"/>
                <a:ext cx="0" cy="17152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3AFC8539-DF58-4BA6-B786-0ED4A4526D3E}"/>
                  </a:ext>
                </a:extLst>
              </p:cNvPr>
              <p:cNvSpPr txBox="1"/>
              <p:nvPr/>
            </p:nvSpPr>
            <p:spPr>
              <a:xfrm>
                <a:off x="376343" y="5863293"/>
                <a:ext cx="1472199" cy="371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µM MO</a:t>
                </a:r>
              </a:p>
            </p:txBody>
          </p:sp>
          <p:grpSp>
            <p:nvGrpSpPr>
              <p:cNvPr id="140" name="Group 5">
                <a:extLst>
                  <a:ext uri="{FF2B5EF4-FFF2-40B4-BE49-F238E27FC236}">
                    <a16:creationId xmlns:a16="http://schemas.microsoft.com/office/drawing/2014/main" id="{0B63B764-2F0E-4181-B2BA-B5A3283125AB}"/>
                  </a:ext>
                </a:extLst>
              </p:cNvPr>
              <p:cNvGrpSpPr/>
              <p:nvPr/>
            </p:nvGrpSpPr>
            <p:grpSpPr>
              <a:xfrm>
                <a:off x="3089922" y="3836130"/>
                <a:ext cx="3018941" cy="2412962"/>
                <a:chOff x="3934651" y="3876601"/>
                <a:chExt cx="3018941" cy="2412962"/>
              </a:xfrm>
            </p:grpSpPr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32AF5D3D-9214-44C7-9F85-FDD54500655F}"/>
                    </a:ext>
                  </a:extLst>
                </p:cNvPr>
                <p:cNvSpPr txBox="1"/>
                <p:nvPr/>
              </p:nvSpPr>
              <p:spPr>
                <a:xfrm>
                  <a:off x="5063942" y="3876601"/>
                  <a:ext cx="1889650" cy="4670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µM SNP</a:t>
                  </a:r>
                </a:p>
              </p:txBody>
            </p:sp>
            <p:cxnSp>
              <p:nvCxnSpPr>
                <p:cNvPr id="148" name="Straight Arrow Connector 147">
                  <a:extLst>
                    <a:ext uri="{FF2B5EF4-FFF2-40B4-BE49-F238E27FC236}">
                      <a16:creationId xmlns:a16="http://schemas.microsoft.com/office/drawing/2014/main" id="{5AA41812-1E6C-4EAF-B06D-4694ABEAD22B}"/>
                    </a:ext>
                  </a:extLst>
                </p:cNvPr>
                <p:cNvCxnSpPr/>
                <p:nvPr/>
              </p:nvCxnSpPr>
              <p:spPr>
                <a:xfrm>
                  <a:off x="5536180" y="4204372"/>
                  <a:ext cx="0" cy="235935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Straight Arrow Connector 148">
                  <a:extLst>
                    <a:ext uri="{FF2B5EF4-FFF2-40B4-BE49-F238E27FC236}">
                      <a16:creationId xmlns:a16="http://schemas.microsoft.com/office/drawing/2014/main" id="{3963FB23-9349-4275-8FC6-9EDDC81112B3}"/>
                    </a:ext>
                  </a:extLst>
                </p:cNvPr>
                <p:cNvCxnSpPr/>
                <p:nvPr/>
              </p:nvCxnSpPr>
              <p:spPr>
                <a:xfrm flipV="1">
                  <a:off x="4651082" y="5745676"/>
                  <a:ext cx="0" cy="17152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TextBox 149">
                  <a:extLst>
                    <a:ext uri="{FF2B5EF4-FFF2-40B4-BE49-F238E27FC236}">
                      <a16:creationId xmlns:a16="http://schemas.microsoft.com/office/drawing/2014/main" id="{3D6D2B56-1CC6-4DAA-B692-4C2FF0F235F2}"/>
                    </a:ext>
                  </a:extLst>
                </p:cNvPr>
                <p:cNvSpPr txBox="1"/>
                <p:nvPr/>
              </p:nvSpPr>
              <p:spPr>
                <a:xfrm>
                  <a:off x="3934651" y="5917672"/>
                  <a:ext cx="1552971" cy="3718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µM MO</a:t>
                  </a:r>
                </a:p>
              </p:txBody>
            </p:sp>
          </p:grpSp>
          <p:grpSp>
            <p:nvGrpSpPr>
              <p:cNvPr id="141" name="Group 67">
                <a:extLst>
                  <a:ext uri="{FF2B5EF4-FFF2-40B4-BE49-F238E27FC236}">
                    <a16:creationId xmlns:a16="http://schemas.microsoft.com/office/drawing/2014/main" id="{C5B94883-4B98-45B1-91B7-6439D77567A6}"/>
                  </a:ext>
                </a:extLst>
              </p:cNvPr>
              <p:cNvGrpSpPr/>
              <p:nvPr/>
            </p:nvGrpSpPr>
            <p:grpSpPr>
              <a:xfrm flipH="1">
                <a:off x="-538265" y="4788324"/>
                <a:ext cx="1901897" cy="777443"/>
                <a:chOff x="5124097" y="1366056"/>
                <a:chExt cx="2243813" cy="777443"/>
              </a:xfrm>
            </p:grpSpPr>
            <p:cxnSp>
              <p:nvCxnSpPr>
                <p:cNvPr id="143" name="Straight Connector 142">
                  <a:extLst>
                    <a:ext uri="{FF2B5EF4-FFF2-40B4-BE49-F238E27FC236}">
                      <a16:creationId xmlns:a16="http://schemas.microsoft.com/office/drawing/2014/main" id="{C178D22B-76AB-4AA1-BDAC-752F64A5DA34}"/>
                    </a:ext>
                  </a:extLst>
                </p:cNvPr>
                <p:cNvCxnSpPr/>
                <p:nvPr/>
              </p:nvCxnSpPr>
              <p:spPr>
                <a:xfrm>
                  <a:off x="6190562" y="1366056"/>
                  <a:ext cx="0" cy="432627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Straight Connector 143">
                  <a:extLst>
                    <a:ext uri="{FF2B5EF4-FFF2-40B4-BE49-F238E27FC236}">
                      <a16:creationId xmlns:a16="http://schemas.microsoft.com/office/drawing/2014/main" id="{3A1F7585-3CCB-4C36-A985-B1883B0AC418}"/>
                    </a:ext>
                  </a:extLst>
                </p:cNvPr>
                <p:cNvCxnSpPr/>
                <p:nvPr/>
              </p:nvCxnSpPr>
              <p:spPr>
                <a:xfrm>
                  <a:off x="5756500" y="1798682"/>
                  <a:ext cx="296417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5" name="TextBox 144">
                  <a:extLst>
                    <a:ext uri="{FF2B5EF4-FFF2-40B4-BE49-F238E27FC236}">
                      <a16:creationId xmlns:a16="http://schemas.microsoft.com/office/drawing/2014/main" id="{3CE8FC57-D29E-4F49-89EB-A0FAC903F2BB}"/>
                    </a:ext>
                  </a:extLst>
                </p:cNvPr>
                <p:cNvSpPr txBox="1"/>
                <p:nvPr/>
              </p:nvSpPr>
              <p:spPr>
                <a:xfrm>
                  <a:off x="6033859" y="1384373"/>
                  <a:ext cx="1334051" cy="3718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mN</a:t>
                  </a:r>
                </a:p>
              </p:txBody>
            </p:sp>
            <p:sp>
              <p:nvSpPr>
                <p:cNvPr id="146" name="TextBox 145">
                  <a:extLst>
                    <a:ext uri="{FF2B5EF4-FFF2-40B4-BE49-F238E27FC236}">
                      <a16:creationId xmlns:a16="http://schemas.microsoft.com/office/drawing/2014/main" id="{8931091A-8992-4B6C-969C-CC4D93D2C2FE}"/>
                    </a:ext>
                  </a:extLst>
                </p:cNvPr>
                <p:cNvSpPr txBox="1"/>
                <p:nvPr/>
              </p:nvSpPr>
              <p:spPr>
                <a:xfrm>
                  <a:off x="5124097" y="1771608"/>
                  <a:ext cx="1561223" cy="3718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 min</a:t>
                  </a:r>
                </a:p>
              </p:txBody>
            </p:sp>
          </p:grp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59B882B3-20A2-4F94-BFDD-DFE49F8F7BF5}"/>
                  </a:ext>
                </a:extLst>
              </p:cNvPr>
              <p:cNvSpPr txBox="1"/>
              <p:nvPr/>
            </p:nvSpPr>
            <p:spPr>
              <a:xfrm>
                <a:off x="3782338" y="5260683"/>
                <a:ext cx="1597748" cy="371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1</a:t>
                </a:r>
                <a:r>
                  <a:rPr lang="en-GB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</a:p>
            </p:txBody>
          </p:sp>
        </p:grpSp>
        <p:sp>
          <p:nvSpPr>
            <p:cNvPr id="165" name="Text Box 19">
              <a:extLst>
                <a:ext uri="{FF2B5EF4-FFF2-40B4-BE49-F238E27FC236}">
                  <a16:creationId xmlns:a16="http://schemas.microsoft.com/office/drawing/2014/main" id="{E61C634E-D577-4591-97C2-530CC42E1B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063568" y="6075642"/>
              <a:ext cx="549332" cy="5415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b="1" dirty="0"/>
                <a:t>C</a:t>
              </a:r>
            </a:p>
          </p:txBody>
        </p:sp>
        <p:sp>
          <p:nvSpPr>
            <p:cNvPr id="86" name="Freeform 31">
              <a:extLst>
                <a:ext uri="{FF2B5EF4-FFF2-40B4-BE49-F238E27FC236}">
                  <a16:creationId xmlns:a16="http://schemas.microsoft.com/office/drawing/2014/main" id="{EF6E3328-F983-4CEA-B3FF-F3FDA9AB7CDD}"/>
                </a:ext>
              </a:extLst>
            </p:cNvPr>
            <p:cNvSpPr>
              <a:spLocks/>
            </p:cNvSpPr>
            <p:nvPr/>
          </p:nvSpPr>
          <p:spPr bwMode="auto">
            <a:xfrm>
              <a:off x="58945" y="6839561"/>
              <a:ext cx="2094382" cy="1306972"/>
            </a:xfrm>
            <a:custGeom>
              <a:avLst/>
              <a:gdLst>
                <a:gd name="T0" fmla="*/ 115 w 7549"/>
                <a:gd name="T1" fmla="*/ 1691 h 1732"/>
                <a:gd name="T2" fmla="*/ 245 w 7549"/>
                <a:gd name="T3" fmla="*/ 1690 h 1732"/>
                <a:gd name="T4" fmla="*/ 376 w 7549"/>
                <a:gd name="T5" fmla="*/ 1692 h 1732"/>
                <a:gd name="T6" fmla="*/ 506 w 7549"/>
                <a:gd name="T7" fmla="*/ 1691 h 1732"/>
                <a:gd name="T8" fmla="*/ 636 w 7549"/>
                <a:gd name="T9" fmla="*/ 1690 h 1732"/>
                <a:gd name="T10" fmla="*/ 766 w 7549"/>
                <a:gd name="T11" fmla="*/ 1691 h 1732"/>
                <a:gd name="T12" fmla="*/ 896 w 7549"/>
                <a:gd name="T13" fmla="*/ 1692 h 1732"/>
                <a:gd name="T14" fmla="*/ 1026 w 7549"/>
                <a:gd name="T15" fmla="*/ 1691 h 1732"/>
                <a:gd name="T16" fmla="*/ 1156 w 7549"/>
                <a:gd name="T17" fmla="*/ 1692 h 1732"/>
                <a:gd name="T18" fmla="*/ 1287 w 7549"/>
                <a:gd name="T19" fmla="*/ 1691 h 1732"/>
                <a:gd name="T20" fmla="*/ 1417 w 7549"/>
                <a:gd name="T21" fmla="*/ 1691 h 1732"/>
                <a:gd name="T22" fmla="*/ 1547 w 7549"/>
                <a:gd name="T23" fmla="*/ 1692 h 1732"/>
                <a:gd name="T24" fmla="*/ 1677 w 7549"/>
                <a:gd name="T25" fmla="*/ 1689 h 1732"/>
                <a:gd name="T26" fmla="*/ 1807 w 7549"/>
                <a:gd name="T27" fmla="*/ 1507 h 1732"/>
                <a:gd name="T28" fmla="*/ 1937 w 7549"/>
                <a:gd name="T29" fmla="*/ 1137 h 1732"/>
                <a:gd name="T30" fmla="*/ 2068 w 7549"/>
                <a:gd name="T31" fmla="*/ 943 h 1732"/>
                <a:gd name="T32" fmla="*/ 2198 w 7549"/>
                <a:gd name="T33" fmla="*/ 818 h 1732"/>
                <a:gd name="T34" fmla="*/ 2328 w 7549"/>
                <a:gd name="T35" fmla="*/ 708 h 1732"/>
                <a:gd name="T36" fmla="*/ 2458 w 7549"/>
                <a:gd name="T37" fmla="*/ 583 h 1732"/>
                <a:gd name="T38" fmla="*/ 2588 w 7549"/>
                <a:gd name="T39" fmla="*/ 520 h 1732"/>
                <a:gd name="T40" fmla="*/ 2718 w 7549"/>
                <a:gd name="T41" fmla="*/ 451 h 1732"/>
                <a:gd name="T42" fmla="*/ 2848 w 7549"/>
                <a:gd name="T43" fmla="*/ 387 h 1732"/>
                <a:gd name="T44" fmla="*/ 2979 w 7549"/>
                <a:gd name="T45" fmla="*/ 303 h 1732"/>
                <a:gd name="T46" fmla="*/ 3109 w 7549"/>
                <a:gd name="T47" fmla="*/ 227 h 1732"/>
                <a:gd name="T48" fmla="*/ 3239 w 7549"/>
                <a:gd name="T49" fmla="*/ 170 h 1732"/>
                <a:gd name="T50" fmla="*/ 3369 w 7549"/>
                <a:gd name="T51" fmla="*/ 160 h 1732"/>
                <a:gd name="T52" fmla="*/ 3499 w 7549"/>
                <a:gd name="T53" fmla="*/ 107 h 1732"/>
                <a:gd name="T54" fmla="*/ 3629 w 7549"/>
                <a:gd name="T55" fmla="*/ 81 h 1732"/>
                <a:gd name="T56" fmla="*/ 3760 w 7549"/>
                <a:gd name="T57" fmla="*/ 77 h 1732"/>
                <a:gd name="T58" fmla="*/ 3890 w 7549"/>
                <a:gd name="T59" fmla="*/ 77 h 1732"/>
                <a:gd name="T60" fmla="*/ 4020 w 7549"/>
                <a:gd name="T61" fmla="*/ 43 h 1732"/>
                <a:gd name="T62" fmla="*/ 4150 w 7549"/>
                <a:gd name="T63" fmla="*/ 13 h 1732"/>
                <a:gd name="T64" fmla="*/ 4280 w 7549"/>
                <a:gd name="T65" fmla="*/ 1 h 1732"/>
                <a:gd name="T66" fmla="*/ 4410 w 7549"/>
                <a:gd name="T67" fmla="*/ 259 h 1732"/>
                <a:gd name="T68" fmla="*/ 4540 w 7549"/>
                <a:gd name="T69" fmla="*/ 869 h 1732"/>
                <a:gd name="T70" fmla="*/ 4671 w 7549"/>
                <a:gd name="T71" fmla="*/ 1240 h 1732"/>
                <a:gd name="T72" fmla="*/ 4801 w 7549"/>
                <a:gd name="T73" fmla="*/ 1416 h 1732"/>
                <a:gd name="T74" fmla="*/ 4931 w 7549"/>
                <a:gd name="T75" fmla="*/ 1511 h 1732"/>
                <a:gd name="T76" fmla="*/ 5061 w 7549"/>
                <a:gd name="T77" fmla="*/ 1562 h 1732"/>
                <a:gd name="T78" fmla="*/ 5191 w 7549"/>
                <a:gd name="T79" fmla="*/ 1594 h 1732"/>
                <a:gd name="T80" fmla="*/ 5321 w 7549"/>
                <a:gd name="T81" fmla="*/ 1613 h 1732"/>
                <a:gd name="T82" fmla="*/ 5452 w 7549"/>
                <a:gd name="T83" fmla="*/ 1628 h 1732"/>
                <a:gd name="T84" fmla="*/ 5582 w 7549"/>
                <a:gd name="T85" fmla="*/ 1639 h 1732"/>
                <a:gd name="T86" fmla="*/ 5712 w 7549"/>
                <a:gd name="T87" fmla="*/ 1647 h 1732"/>
                <a:gd name="T88" fmla="*/ 5842 w 7549"/>
                <a:gd name="T89" fmla="*/ 1655 h 1732"/>
                <a:gd name="T90" fmla="*/ 5972 w 7549"/>
                <a:gd name="T91" fmla="*/ 1665 h 1732"/>
                <a:gd name="T92" fmla="*/ 6102 w 7549"/>
                <a:gd name="T93" fmla="*/ 1670 h 1732"/>
                <a:gd name="T94" fmla="*/ 6232 w 7549"/>
                <a:gd name="T95" fmla="*/ 1670 h 1732"/>
                <a:gd name="T96" fmla="*/ 6363 w 7549"/>
                <a:gd name="T97" fmla="*/ 1679 h 1732"/>
                <a:gd name="T98" fmla="*/ 6493 w 7549"/>
                <a:gd name="T99" fmla="*/ 1680 h 1732"/>
                <a:gd name="T100" fmla="*/ 6623 w 7549"/>
                <a:gd name="T101" fmla="*/ 1689 h 1732"/>
                <a:gd name="T102" fmla="*/ 6753 w 7549"/>
                <a:gd name="T103" fmla="*/ 1699 h 1732"/>
                <a:gd name="T104" fmla="*/ 6883 w 7549"/>
                <a:gd name="T105" fmla="*/ 1730 h 1732"/>
                <a:gd name="T106" fmla="*/ 7013 w 7549"/>
                <a:gd name="T107" fmla="*/ 1693 h 1732"/>
                <a:gd name="T108" fmla="*/ 7144 w 7549"/>
                <a:gd name="T109" fmla="*/ 1707 h 1732"/>
                <a:gd name="T110" fmla="*/ 7274 w 7549"/>
                <a:gd name="T111" fmla="*/ 1716 h 1732"/>
                <a:gd name="T112" fmla="*/ 7404 w 7549"/>
                <a:gd name="T113" fmla="*/ 1720 h 1732"/>
                <a:gd name="T114" fmla="*/ 7534 w 7549"/>
                <a:gd name="T115" fmla="*/ 1725 h 17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7549" h="1732">
                  <a:moveTo>
                    <a:pt x="0" y="1689"/>
                  </a:moveTo>
                  <a:lnTo>
                    <a:pt x="14" y="1689"/>
                  </a:lnTo>
                  <a:lnTo>
                    <a:pt x="28" y="1690"/>
                  </a:lnTo>
                  <a:lnTo>
                    <a:pt x="43" y="1691"/>
                  </a:lnTo>
                  <a:lnTo>
                    <a:pt x="57" y="1689"/>
                  </a:lnTo>
                  <a:lnTo>
                    <a:pt x="72" y="1689"/>
                  </a:lnTo>
                  <a:lnTo>
                    <a:pt x="86" y="1689"/>
                  </a:lnTo>
                  <a:lnTo>
                    <a:pt x="101" y="1691"/>
                  </a:lnTo>
                  <a:lnTo>
                    <a:pt x="115" y="1691"/>
                  </a:lnTo>
                  <a:lnTo>
                    <a:pt x="130" y="1691"/>
                  </a:lnTo>
                  <a:lnTo>
                    <a:pt x="144" y="1690"/>
                  </a:lnTo>
                  <a:lnTo>
                    <a:pt x="159" y="1691"/>
                  </a:lnTo>
                  <a:lnTo>
                    <a:pt x="173" y="1691"/>
                  </a:lnTo>
                  <a:lnTo>
                    <a:pt x="188" y="1691"/>
                  </a:lnTo>
                  <a:lnTo>
                    <a:pt x="202" y="1690"/>
                  </a:lnTo>
                  <a:lnTo>
                    <a:pt x="216" y="1690"/>
                  </a:lnTo>
                  <a:lnTo>
                    <a:pt x="231" y="1691"/>
                  </a:lnTo>
                  <a:lnTo>
                    <a:pt x="245" y="1690"/>
                  </a:lnTo>
                  <a:lnTo>
                    <a:pt x="260" y="1691"/>
                  </a:lnTo>
                  <a:lnTo>
                    <a:pt x="274" y="1691"/>
                  </a:lnTo>
                  <a:lnTo>
                    <a:pt x="289" y="1689"/>
                  </a:lnTo>
                  <a:lnTo>
                    <a:pt x="303" y="1691"/>
                  </a:lnTo>
                  <a:lnTo>
                    <a:pt x="318" y="1691"/>
                  </a:lnTo>
                  <a:lnTo>
                    <a:pt x="332" y="1690"/>
                  </a:lnTo>
                  <a:lnTo>
                    <a:pt x="347" y="1692"/>
                  </a:lnTo>
                  <a:lnTo>
                    <a:pt x="361" y="1692"/>
                  </a:lnTo>
                  <a:lnTo>
                    <a:pt x="376" y="1692"/>
                  </a:lnTo>
                  <a:lnTo>
                    <a:pt x="390" y="1691"/>
                  </a:lnTo>
                  <a:lnTo>
                    <a:pt x="404" y="1691"/>
                  </a:lnTo>
                  <a:lnTo>
                    <a:pt x="419" y="1692"/>
                  </a:lnTo>
                  <a:lnTo>
                    <a:pt x="433" y="1690"/>
                  </a:lnTo>
                  <a:lnTo>
                    <a:pt x="448" y="1691"/>
                  </a:lnTo>
                  <a:lnTo>
                    <a:pt x="462" y="1692"/>
                  </a:lnTo>
                  <a:lnTo>
                    <a:pt x="477" y="1691"/>
                  </a:lnTo>
                  <a:lnTo>
                    <a:pt x="491" y="1691"/>
                  </a:lnTo>
                  <a:lnTo>
                    <a:pt x="506" y="1691"/>
                  </a:lnTo>
                  <a:lnTo>
                    <a:pt x="520" y="1691"/>
                  </a:lnTo>
                  <a:lnTo>
                    <a:pt x="535" y="1692"/>
                  </a:lnTo>
                  <a:lnTo>
                    <a:pt x="549" y="1691"/>
                  </a:lnTo>
                  <a:lnTo>
                    <a:pt x="564" y="1691"/>
                  </a:lnTo>
                  <a:lnTo>
                    <a:pt x="578" y="1692"/>
                  </a:lnTo>
                  <a:lnTo>
                    <a:pt x="592" y="1690"/>
                  </a:lnTo>
                  <a:lnTo>
                    <a:pt x="607" y="1691"/>
                  </a:lnTo>
                  <a:lnTo>
                    <a:pt x="621" y="1691"/>
                  </a:lnTo>
                  <a:lnTo>
                    <a:pt x="636" y="1690"/>
                  </a:lnTo>
                  <a:lnTo>
                    <a:pt x="650" y="1690"/>
                  </a:lnTo>
                  <a:lnTo>
                    <a:pt x="665" y="1694"/>
                  </a:lnTo>
                  <a:lnTo>
                    <a:pt x="679" y="1692"/>
                  </a:lnTo>
                  <a:lnTo>
                    <a:pt x="694" y="1690"/>
                  </a:lnTo>
                  <a:lnTo>
                    <a:pt x="708" y="1692"/>
                  </a:lnTo>
                  <a:lnTo>
                    <a:pt x="723" y="1693"/>
                  </a:lnTo>
                  <a:lnTo>
                    <a:pt x="737" y="1692"/>
                  </a:lnTo>
                  <a:lnTo>
                    <a:pt x="752" y="1694"/>
                  </a:lnTo>
                  <a:lnTo>
                    <a:pt x="766" y="1691"/>
                  </a:lnTo>
                  <a:lnTo>
                    <a:pt x="780" y="1692"/>
                  </a:lnTo>
                  <a:lnTo>
                    <a:pt x="795" y="1692"/>
                  </a:lnTo>
                  <a:lnTo>
                    <a:pt x="809" y="1691"/>
                  </a:lnTo>
                  <a:lnTo>
                    <a:pt x="824" y="1693"/>
                  </a:lnTo>
                  <a:lnTo>
                    <a:pt x="838" y="1691"/>
                  </a:lnTo>
                  <a:lnTo>
                    <a:pt x="853" y="1690"/>
                  </a:lnTo>
                  <a:lnTo>
                    <a:pt x="867" y="1692"/>
                  </a:lnTo>
                  <a:lnTo>
                    <a:pt x="882" y="1691"/>
                  </a:lnTo>
                  <a:lnTo>
                    <a:pt x="896" y="1692"/>
                  </a:lnTo>
                  <a:lnTo>
                    <a:pt x="911" y="1691"/>
                  </a:lnTo>
                  <a:lnTo>
                    <a:pt x="925" y="1692"/>
                  </a:lnTo>
                  <a:lnTo>
                    <a:pt x="940" y="1690"/>
                  </a:lnTo>
                  <a:lnTo>
                    <a:pt x="954" y="1690"/>
                  </a:lnTo>
                  <a:lnTo>
                    <a:pt x="968" y="1691"/>
                  </a:lnTo>
                  <a:lnTo>
                    <a:pt x="983" y="1691"/>
                  </a:lnTo>
                  <a:lnTo>
                    <a:pt x="997" y="1691"/>
                  </a:lnTo>
                  <a:lnTo>
                    <a:pt x="1012" y="1691"/>
                  </a:lnTo>
                  <a:lnTo>
                    <a:pt x="1026" y="1691"/>
                  </a:lnTo>
                  <a:lnTo>
                    <a:pt x="1041" y="1690"/>
                  </a:lnTo>
                  <a:lnTo>
                    <a:pt x="1055" y="1690"/>
                  </a:lnTo>
                  <a:lnTo>
                    <a:pt x="1070" y="1691"/>
                  </a:lnTo>
                  <a:lnTo>
                    <a:pt x="1084" y="1692"/>
                  </a:lnTo>
                  <a:lnTo>
                    <a:pt x="1099" y="1692"/>
                  </a:lnTo>
                  <a:lnTo>
                    <a:pt x="1113" y="1692"/>
                  </a:lnTo>
                  <a:lnTo>
                    <a:pt x="1128" y="1692"/>
                  </a:lnTo>
                  <a:lnTo>
                    <a:pt x="1142" y="1694"/>
                  </a:lnTo>
                  <a:lnTo>
                    <a:pt x="1156" y="1692"/>
                  </a:lnTo>
                  <a:lnTo>
                    <a:pt x="1171" y="1693"/>
                  </a:lnTo>
                  <a:lnTo>
                    <a:pt x="1185" y="1691"/>
                  </a:lnTo>
                  <a:lnTo>
                    <a:pt x="1200" y="1691"/>
                  </a:lnTo>
                  <a:lnTo>
                    <a:pt x="1214" y="1690"/>
                  </a:lnTo>
                  <a:lnTo>
                    <a:pt x="1229" y="1691"/>
                  </a:lnTo>
                  <a:lnTo>
                    <a:pt x="1243" y="1692"/>
                  </a:lnTo>
                  <a:lnTo>
                    <a:pt x="1258" y="1691"/>
                  </a:lnTo>
                  <a:lnTo>
                    <a:pt x="1272" y="1691"/>
                  </a:lnTo>
                  <a:lnTo>
                    <a:pt x="1287" y="1691"/>
                  </a:lnTo>
                  <a:lnTo>
                    <a:pt x="1301" y="1691"/>
                  </a:lnTo>
                  <a:lnTo>
                    <a:pt x="1316" y="1690"/>
                  </a:lnTo>
                  <a:lnTo>
                    <a:pt x="1330" y="1690"/>
                  </a:lnTo>
                  <a:lnTo>
                    <a:pt x="1344" y="1690"/>
                  </a:lnTo>
                  <a:lnTo>
                    <a:pt x="1359" y="1692"/>
                  </a:lnTo>
                  <a:lnTo>
                    <a:pt x="1373" y="1692"/>
                  </a:lnTo>
                  <a:lnTo>
                    <a:pt x="1388" y="1692"/>
                  </a:lnTo>
                  <a:lnTo>
                    <a:pt x="1402" y="1692"/>
                  </a:lnTo>
                  <a:lnTo>
                    <a:pt x="1417" y="1691"/>
                  </a:lnTo>
                  <a:lnTo>
                    <a:pt x="1431" y="1691"/>
                  </a:lnTo>
                  <a:lnTo>
                    <a:pt x="1446" y="1691"/>
                  </a:lnTo>
                  <a:lnTo>
                    <a:pt x="1460" y="1691"/>
                  </a:lnTo>
                  <a:lnTo>
                    <a:pt x="1475" y="1690"/>
                  </a:lnTo>
                  <a:lnTo>
                    <a:pt x="1489" y="1692"/>
                  </a:lnTo>
                  <a:lnTo>
                    <a:pt x="1504" y="1691"/>
                  </a:lnTo>
                  <a:lnTo>
                    <a:pt x="1518" y="1690"/>
                  </a:lnTo>
                  <a:lnTo>
                    <a:pt x="1532" y="1691"/>
                  </a:lnTo>
                  <a:lnTo>
                    <a:pt x="1547" y="1692"/>
                  </a:lnTo>
                  <a:lnTo>
                    <a:pt x="1561" y="1692"/>
                  </a:lnTo>
                  <a:lnTo>
                    <a:pt x="1576" y="1691"/>
                  </a:lnTo>
                  <a:lnTo>
                    <a:pt x="1590" y="1690"/>
                  </a:lnTo>
                  <a:lnTo>
                    <a:pt x="1605" y="1692"/>
                  </a:lnTo>
                  <a:lnTo>
                    <a:pt x="1619" y="1692"/>
                  </a:lnTo>
                  <a:lnTo>
                    <a:pt x="1634" y="1691"/>
                  </a:lnTo>
                  <a:lnTo>
                    <a:pt x="1648" y="1691"/>
                  </a:lnTo>
                  <a:lnTo>
                    <a:pt x="1663" y="1692"/>
                  </a:lnTo>
                  <a:lnTo>
                    <a:pt x="1677" y="1689"/>
                  </a:lnTo>
                  <a:lnTo>
                    <a:pt x="1692" y="1691"/>
                  </a:lnTo>
                  <a:lnTo>
                    <a:pt x="1706" y="1688"/>
                  </a:lnTo>
                  <a:lnTo>
                    <a:pt x="1720" y="1676"/>
                  </a:lnTo>
                  <a:lnTo>
                    <a:pt x="1735" y="1661"/>
                  </a:lnTo>
                  <a:lnTo>
                    <a:pt x="1749" y="1643"/>
                  </a:lnTo>
                  <a:lnTo>
                    <a:pt x="1764" y="1622"/>
                  </a:lnTo>
                  <a:lnTo>
                    <a:pt x="1778" y="1601"/>
                  </a:lnTo>
                  <a:lnTo>
                    <a:pt x="1793" y="1569"/>
                  </a:lnTo>
                  <a:lnTo>
                    <a:pt x="1807" y="1507"/>
                  </a:lnTo>
                  <a:lnTo>
                    <a:pt x="1822" y="1455"/>
                  </a:lnTo>
                  <a:lnTo>
                    <a:pt x="1836" y="1434"/>
                  </a:lnTo>
                  <a:lnTo>
                    <a:pt x="1851" y="1419"/>
                  </a:lnTo>
                  <a:lnTo>
                    <a:pt x="1865" y="1385"/>
                  </a:lnTo>
                  <a:lnTo>
                    <a:pt x="1880" y="1325"/>
                  </a:lnTo>
                  <a:lnTo>
                    <a:pt x="1894" y="1257"/>
                  </a:lnTo>
                  <a:lnTo>
                    <a:pt x="1908" y="1209"/>
                  </a:lnTo>
                  <a:lnTo>
                    <a:pt x="1923" y="1167"/>
                  </a:lnTo>
                  <a:lnTo>
                    <a:pt x="1937" y="1137"/>
                  </a:lnTo>
                  <a:lnTo>
                    <a:pt x="1952" y="1106"/>
                  </a:lnTo>
                  <a:lnTo>
                    <a:pt x="1966" y="1078"/>
                  </a:lnTo>
                  <a:lnTo>
                    <a:pt x="1981" y="1051"/>
                  </a:lnTo>
                  <a:lnTo>
                    <a:pt x="1995" y="1017"/>
                  </a:lnTo>
                  <a:lnTo>
                    <a:pt x="2010" y="986"/>
                  </a:lnTo>
                  <a:lnTo>
                    <a:pt x="2024" y="965"/>
                  </a:lnTo>
                  <a:lnTo>
                    <a:pt x="2039" y="964"/>
                  </a:lnTo>
                  <a:lnTo>
                    <a:pt x="2053" y="961"/>
                  </a:lnTo>
                  <a:lnTo>
                    <a:pt x="2068" y="943"/>
                  </a:lnTo>
                  <a:lnTo>
                    <a:pt x="2082" y="928"/>
                  </a:lnTo>
                  <a:lnTo>
                    <a:pt x="2096" y="898"/>
                  </a:lnTo>
                  <a:lnTo>
                    <a:pt x="2111" y="872"/>
                  </a:lnTo>
                  <a:lnTo>
                    <a:pt x="2125" y="857"/>
                  </a:lnTo>
                  <a:lnTo>
                    <a:pt x="2140" y="853"/>
                  </a:lnTo>
                  <a:lnTo>
                    <a:pt x="2154" y="851"/>
                  </a:lnTo>
                  <a:lnTo>
                    <a:pt x="2169" y="846"/>
                  </a:lnTo>
                  <a:lnTo>
                    <a:pt x="2183" y="834"/>
                  </a:lnTo>
                  <a:lnTo>
                    <a:pt x="2198" y="818"/>
                  </a:lnTo>
                  <a:lnTo>
                    <a:pt x="2212" y="796"/>
                  </a:lnTo>
                  <a:lnTo>
                    <a:pt x="2227" y="783"/>
                  </a:lnTo>
                  <a:lnTo>
                    <a:pt x="2241" y="766"/>
                  </a:lnTo>
                  <a:lnTo>
                    <a:pt x="2256" y="755"/>
                  </a:lnTo>
                  <a:lnTo>
                    <a:pt x="2270" y="744"/>
                  </a:lnTo>
                  <a:lnTo>
                    <a:pt x="2284" y="735"/>
                  </a:lnTo>
                  <a:lnTo>
                    <a:pt x="2299" y="729"/>
                  </a:lnTo>
                  <a:lnTo>
                    <a:pt x="2313" y="717"/>
                  </a:lnTo>
                  <a:lnTo>
                    <a:pt x="2328" y="708"/>
                  </a:lnTo>
                  <a:lnTo>
                    <a:pt x="2342" y="693"/>
                  </a:lnTo>
                  <a:lnTo>
                    <a:pt x="2357" y="681"/>
                  </a:lnTo>
                  <a:lnTo>
                    <a:pt x="2371" y="659"/>
                  </a:lnTo>
                  <a:lnTo>
                    <a:pt x="2386" y="649"/>
                  </a:lnTo>
                  <a:lnTo>
                    <a:pt x="2400" y="636"/>
                  </a:lnTo>
                  <a:lnTo>
                    <a:pt x="2415" y="620"/>
                  </a:lnTo>
                  <a:lnTo>
                    <a:pt x="2429" y="605"/>
                  </a:lnTo>
                  <a:lnTo>
                    <a:pt x="2444" y="593"/>
                  </a:lnTo>
                  <a:lnTo>
                    <a:pt x="2458" y="583"/>
                  </a:lnTo>
                  <a:lnTo>
                    <a:pt x="2472" y="566"/>
                  </a:lnTo>
                  <a:lnTo>
                    <a:pt x="2487" y="555"/>
                  </a:lnTo>
                  <a:lnTo>
                    <a:pt x="2501" y="548"/>
                  </a:lnTo>
                  <a:lnTo>
                    <a:pt x="2516" y="538"/>
                  </a:lnTo>
                  <a:lnTo>
                    <a:pt x="2530" y="534"/>
                  </a:lnTo>
                  <a:lnTo>
                    <a:pt x="2545" y="530"/>
                  </a:lnTo>
                  <a:lnTo>
                    <a:pt x="2559" y="533"/>
                  </a:lnTo>
                  <a:lnTo>
                    <a:pt x="2574" y="531"/>
                  </a:lnTo>
                  <a:lnTo>
                    <a:pt x="2588" y="520"/>
                  </a:lnTo>
                  <a:lnTo>
                    <a:pt x="2603" y="506"/>
                  </a:lnTo>
                  <a:lnTo>
                    <a:pt x="2617" y="498"/>
                  </a:lnTo>
                  <a:lnTo>
                    <a:pt x="2632" y="489"/>
                  </a:lnTo>
                  <a:lnTo>
                    <a:pt x="2646" y="480"/>
                  </a:lnTo>
                  <a:lnTo>
                    <a:pt x="2660" y="476"/>
                  </a:lnTo>
                  <a:lnTo>
                    <a:pt x="2675" y="472"/>
                  </a:lnTo>
                  <a:lnTo>
                    <a:pt x="2689" y="464"/>
                  </a:lnTo>
                  <a:lnTo>
                    <a:pt x="2704" y="454"/>
                  </a:lnTo>
                  <a:lnTo>
                    <a:pt x="2718" y="451"/>
                  </a:lnTo>
                  <a:lnTo>
                    <a:pt x="2733" y="445"/>
                  </a:lnTo>
                  <a:lnTo>
                    <a:pt x="2747" y="441"/>
                  </a:lnTo>
                  <a:lnTo>
                    <a:pt x="2762" y="425"/>
                  </a:lnTo>
                  <a:lnTo>
                    <a:pt x="2776" y="413"/>
                  </a:lnTo>
                  <a:lnTo>
                    <a:pt x="2791" y="403"/>
                  </a:lnTo>
                  <a:lnTo>
                    <a:pt x="2805" y="396"/>
                  </a:lnTo>
                  <a:lnTo>
                    <a:pt x="2820" y="394"/>
                  </a:lnTo>
                  <a:lnTo>
                    <a:pt x="2834" y="395"/>
                  </a:lnTo>
                  <a:lnTo>
                    <a:pt x="2848" y="387"/>
                  </a:lnTo>
                  <a:lnTo>
                    <a:pt x="2863" y="375"/>
                  </a:lnTo>
                  <a:lnTo>
                    <a:pt x="2877" y="362"/>
                  </a:lnTo>
                  <a:lnTo>
                    <a:pt x="2892" y="354"/>
                  </a:lnTo>
                  <a:lnTo>
                    <a:pt x="2906" y="345"/>
                  </a:lnTo>
                  <a:lnTo>
                    <a:pt x="2921" y="341"/>
                  </a:lnTo>
                  <a:lnTo>
                    <a:pt x="2935" y="335"/>
                  </a:lnTo>
                  <a:lnTo>
                    <a:pt x="2950" y="326"/>
                  </a:lnTo>
                  <a:lnTo>
                    <a:pt x="2964" y="311"/>
                  </a:lnTo>
                  <a:lnTo>
                    <a:pt x="2979" y="303"/>
                  </a:lnTo>
                  <a:lnTo>
                    <a:pt x="2993" y="296"/>
                  </a:lnTo>
                  <a:lnTo>
                    <a:pt x="3008" y="292"/>
                  </a:lnTo>
                  <a:lnTo>
                    <a:pt x="3022" y="281"/>
                  </a:lnTo>
                  <a:lnTo>
                    <a:pt x="3036" y="270"/>
                  </a:lnTo>
                  <a:lnTo>
                    <a:pt x="3051" y="258"/>
                  </a:lnTo>
                  <a:lnTo>
                    <a:pt x="3065" y="249"/>
                  </a:lnTo>
                  <a:lnTo>
                    <a:pt x="3080" y="241"/>
                  </a:lnTo>
                  <a:lnTo>
                    <a:pt x="3094" y="235"/>
                  </a:lnTo>
                  <a:lnTo>
                    <a:pt x="3109" y="227"/>
                  </a:lnTo>
                  <a:lnTo>
                    <a:pt x="3123" y="218"/>
                  </a:lnTo>
                  <a:lnTo>
                    <a:pt x="3138" y="210"/>
                  </a:lnTo>
                  <a:lnTo>
                    <a:pt x="3152" y="203"/>
                  </a:lnTo>
                  <a:lnTo>
                    <a:pt x="3167" y="200"/>
                  </a:lnTo>
                  <a:lnTo>
                    <a:pt x="3181" y="196"/>
                  </a:lnTo>
                  <a:lnTo>
                    <a:pt x="3196" y="193"/>
                  </a:lnTo>
                  <a:lnTo>
                    <a:pt x="3210" y="181"/>
                  </a:lnTo>
                  <a:lnTo>
                    <a:pt x="3224" y="171"/>
                  </a:lnTo>
                  <a:lnTo>
                    <a:pt x="3239" y="170"/>
                  </a:lnTo>
                  <a:lnTo>
                    <a:pt x="3253" y="170"/>
                  </a:lnTo>
                  <a:lnTo>
                    <a:pt x="3268" y="170"/>
                  </a:lnTo>
                  <a:lnTo>
                    <a:pt x="3282" y="172"/>
                  </a:lnTo>
                  <a:lnTo>
                    <a:pt x="3297" y="170"/>
                  </a:lnTo>
                  <a:lnTo>
                    <a:pt x="3311" y="167"/>
                  </a:lnTo>
                  <a:lnTo>
                    <a:pt x="3326" y="168"/>
                  </a:lnTo>
                  <a:lnTo>
                    <a:pt x="3340" y="170"/>
                  </a:lnTo>
                  <a:lnTo>
                    <a:pt x="3355" y="164"/>
                  </a:lnTo>
                  <a:lnTo>
                    <a:pt x="3369" y="160"/>
                  </a:lnTo>
                  <a:lnTo>
                    <a:pt x="3384" y="155"/>
                  </a:lnTo>
                  <a:lnTo>
                    <a:pt x="3398" y="149"/>
                  </a:lnTo>
                  <a:lnTo>
                    <a:pt x="3412" y="142"/>
                  </a:lnTo>
                  <a:lnTo>
                    <a:pt x="3427" y="139"/>
                  </a:lnTo>
                  <a:lnTo>
                    <a:pt x="3441" y="133"/>
                  </a:lnTo>
                  <a:lnTo>
                    <a:pt x="3456" y="124"/>
                  </a:lnTo>
                  <a:lnTo>
                    <a:pt x="3470" y="120"/>
                  </a:lnTo>
                  <a:lnTo>
                    <a:pt x="3485" y="112"/>
                  </a:lnTo>
                  <a:lnTo>
                    <a:pt x="3499" y="107"/>
                  </a:lnTo>
                  <a:lnTo>
                    <a:pt x="3514" y="105"/>
                  </a:lnTo>
                  <a:lnTo>
                    <a:pt x="3528" y="100"/>
                  </a:lnTo>
                  <a:lnTo>
                    <a:pt x="3543" y="98"/>
                  </a:lnTo>
                  <a:lnTo>
                    <a:pt x="3557" y="96"/>
                  </a:lnTo>
                  <a:lnTo>
                    <a:pt x="3572" y="93"/>
                  </a:lnTo>
                  <a:lnTo>
                    <a:pt x="3586" y="90"/>
                  </a:lnTo>
                  <a:lnTo>
                    <a:pt x="3600" y="85"/>
                  </a:lnTo>
                  <a:lnTo>
                    <a:pt x="3615" y="83"/>
                  </a:lnTo>
                  <a:lnTo>
                    <a:pt x="3629" y="81"/>
                  </a:lnTo>
                  <a:lnTo>
                    <a:pt x="3644" y="80"/>
                  </a:lnTo>
                  <a:lnTo>
                    <a:pt x="3658" y="79"/>
                  </a:lnTo>
                  <a:lnTo>
                    <a:pt x="3673" y="80"/>
                  </a:lnTo>
                  <a:lnTo>
                    <a:pt x="3687" y="78"/>
                  </a:lnTo>
                  <a:lnTo>
                    <a:pt x="3702" y="80"/>
                  </a:lnTo>
                  <a:lnTo>
                    <a:pt x="3716" y="81"/>
                  </a:lnTo>
                  <a:lnTo>
                    <a:pt x="3731" y="83"/>
                  </a:lnTo>
                  <a:lnTo>
                    <a:pt x="3745" y="80"/>
                  </a:lnTo>
                  <a:lnTo>
                    <a:pt x="3760" y="77"/>
                  </a:lnTo>
                  <a:lnTo>
                    <a:pt x="3774" y="75"/>
                  </a:lnTo>
                  <a:lnTo>
                    <a:pt x="3788" y="81"/>
                  </a:lnTo>
                  <a:lnTo>
                    <a:pt x="3803" y="91"/>
                  </a:lnTo>
                  <a:lnTo>
                    <a:pt x="3817" y="101"/>
                  </a:lnTo>
                  <a:lnTo>
                    <a:pt x="3832" y="96"/>
                  </a:lnTo>
                  <a:lnTo>
                    <a:pt x="3846" y="86"/>
                  </a:lnTo>
                  <a:lnTo>
                    <a:pt x="3861" y="74"/>
                  </a:lnTo>
                  <a:lnTo>
                    <a:pt x="3875" y="74"/>
                  </a:lnTo>
                  <a:lnTo>
                    <a:pt x="3890" y="77"/>
                  </a:lnTo>
                  <a:lnTo>
                    <a:pt x="3904" y="83"/>
                  </a:lnTo>
                  <a:lnTo>
                    <a:pt x="3919" y="81"/>
                  </a:lnTo>
                  <a:lnTo>
                    <a:pt x="3933" y="72"/>
                  </a:lnTo>
                  <a:lnTo>
                    <a:pt x="3948" y="62"/>
                  </a:lnTo>
                  <a:lnTo>
                    <a:pt x="3962" y="58"/>
                  </a:lnTo>
                  <a:lnTo>
                    <a:pt x="3976" y="56"/>
                  </a:lnTo>
                  <a:lnTo>
                    <a:pt x="3991" y="55"/>
                  </a:lnTo>
                  <a:lnTo>
                    <a:pt x="4005" y="52"/>
                  </a:lnTo>
                  <a:lnTo>
                    <a:pt x="4020" y="43"/>
                  </a:lnTo>
                  <a:lnTo>
                    <a:pt x="4034" y="37"/>
                  </a:lnTo>
                  <a:lnTo>
                    <a:pt x="4049" y="32"/>
                  </a:lnTo>
                  <a:lnTo>
                    <a:pt x="4063" y="28"/>
                  </a:lnTo>
                  <a:lnTo>
                    <a:pt x="4078" y="27"/>
                  </a:lnTo>
                  <a:lnTo>
                    <a:pt x="4092" y="23"/>
                  </a:lnTo>
                  <a:lnTo>
                    <a:pt x="4107" y="19"/>
                  </a:lnTo>
                  <a:lnTo>
                    <a:pt x="4121" y="16"/>
                  </a:lnTo>
                  <a:lnTo>
                    <a:pt x="4136" y="15"/>
                  </a:lnTo>
                  <a:lnTo>
                    <a:pt x="4150" y="13"/>
                  </a:lnTo>
                  <a:lnTo>
                    <a:pt x="4164" y="15"/>
                  </a:lnTo>
                  <a:lnTo>
                    <a:pt x="4179" y="13"/>
                  </a:lnTo>
                  <a:lnTo>
                    <a:pt x="4193" y="10"/>
                  </a:lnTo>
                  <a:lnTo>
                    <a:pt x="4208" y="9"/>
                  </a:lnTo>
                  <a:lnTo>
                    <a:pt x="4222" y="10"/>
                  </a:lnTo>
                  <a:lnTo>
                    <a:pt x="4237" y="9"/>
                  </a:lnTo>
                  <a:lnTo>
                    <a:pt x="4251" y="5"/>
                  </a:lnTo>
                  <a:lnTo>
                    <a:pt x="4266" y="3"/>
                  </a:lnTo>
                  <a:lnTo>
                    <a:pt x="4280" y="1"/>
                  </a:lnTo>
                  <a:lnTo>
                    <a:pt x="4295" y="0"/>
                  </a:lnTo>
                  <a:lnTo>
                    <a:pt x="4309" y="0"/>
                  </a:lnTo>
                  <a:lnTo>
                    <a:pt x="4324" y="2"/>
                  </a:lnTo>
                  <a:lnTo>
                    <a:pt x="4338" y="10"/>
                  </a:lnTo>
                  <a:lnTo>
                    <a:pt x="4352" y="20"/>
                  </a:lnTo>
                  <a:lnTo>
                    <a:pt x="4367" y="50"/>
                  </a:lnTo>
                  <a:lnTo>
                    <a:pt x="4381" y="103"/>
                  </a:lnTo>
                  <a:lnTo>
                    <a:pt x="4396" y="175"/>
                  </a:lnTo>
                  <a:lnTo>
                    <a:pt x="4410" y="259"/>
                  </a:lnTo>
                  <a:lnTo>
                    <a:pt x="4425" y="329"/>
                  </a:lnTo>
                  <a:lnTo>
                    <a:pt x="4439" y="396"/>
                  </a:lnTo>
                  <a:lnTo>
                    <a:pt x="4454" y="473"/>
                  </a:lnTo>
                  <a:lnTo>
                    <a:pt x="4468" y="535"/>
                  </a:lnTo>
                  <a:lnTo>
                    <a:pt x="4483" y="605"/>
                  </a:lnTo>
                  <a:lnTo>
                    <a:pt x="4497" y="683"/>
                  </a:lnTo>
                  <a:lnTo>
                    <a:pt x="4512" y="737"/>
                  </a:lnTo>
                  <a:lnTo>
                    <a:pt x="4526" y="809"/>
                  </a:lnTo>
                  <a:lnTo>
                    <a:pt x="4540" y="869"/>
                  </a:lnTo>
                  <a:lnTo>
                    <a:pt x="4555" y="912"/>
                  </a:lnTo>
                  <a:lnTo>
                    <a:pt x="4569" y="983"/>
                  </a:lnTo>
                  <a:lnTo>
                    <a:pt x="4584" y="1029"/>
                  </a:lnTo>
                  <a:lnTo>
                    <a:pt x="4598" y="1066"/>
                  </a:lnTo>
                  <a:lnTo>
                    <a:pt x="4613" y="1108"/>
                  </a:lnTo>
                  <a:lnTo>
                    <a:pt x="4627" y="1143"/>
                  </a:lnTo>
                  <a:lnTo>
                    <a:pt x="4642" y="1183"/>
                  </a:lnTo>
                  <a:lnTo>
                    <a:pt x="4656" y="1213"/>
                  </a:lnTo>
                  <a:lnTo>
                    <a:pt x="4671" y="1240"/>
                  </a:lnTo>
                  <a:lnTo>
                    <a:pt x="4685" y="1265"/>
                  </a:lnTo>
                  <a:lnTo>
                    <a:pt x="4700" y="1294"/>
                  </a:lnTo>
                  <a:lnTo>
                    <a:pt x="4714" y="1317"/>
                  </a:lnTo>
                  <a:lnTo>
                    <a:pt x="4728" y="1333"/>
                  </a:lnTo>
                  <a:lnTo>
                    <a:pt x="4743" y="1356"/>
                  </a:lnTo>
                  <a:lnTo>
                    <a:pt x="4757" y="1371"/>
                  </a:lnTo>
                  <a:lnTo>
                    <a:pt x="4772" y="1392"/>
                  </a:lnTo>
                  <a:lnTo>
                    <a:pt x="4786" y="1407"/>
                  </a:lnTo>
                  <a:lnTo>
                    <a:pt x="4801" y="1416"/>
                  </a:lnTo>
                  <a:lnTo>
                    <a:pt x="4815" y="1435"/>
                  </a:lnTo>
                  <a:lnTo>
                    <a:pt x="4830" y="1446"/>
                  </a:lnTo>
                  <a:lnTo>
                    <a:pt x="4844" y="1454"/>
                  </a:lnTo>
                  <a:lnTo>
                    <a:pt x="4859" y="1469"/>
                  </a:lnTo>
                  <a:lnTo>
                    <a:pt x="4873" y="1475"/>
                  </a:lnTo>
                  <a:lnTo>
                    <a:pt x="4888" y="1484"/>
                  </a:lnTo>
                  <a:lnTo>
                    <a:pt x="4902" y="1493"/>
                  </a:lnTo>
                  <a:lnTo>
                    <a:pt x="4916" y="1503"/>
                  </a:lnTo>
                  <a:lnTo>
                    <a:pt x="4931" y="1511"/>
                  </a:lnTo>
                  <a:lnTo>
                    <a:pt x="4945" y="1520"/>
                  </a:lnTo>
                  <a:lnTo>
                    <a:pt x="4960" y="1524"/>
                  </a:lnTo>
                  <a:lnTo>
                    <a:pt x="4974" y="1533"/>
                  </a:lnTo>
                  <a:lnTo>
                    <a:pt x="4989" y="1538"/>
                  </a:lnTo>
                  <a:lnTo>
                    <a:pt x="5003" y="1543"/>
                  </a:lnTo>
                  <a:lnTo>
                    <a:pt x="5018" y="1548"/>
                  </a:lnTo>
                  <a:lnTo>
                    <a:pt x="5032" y="1551"/>
                  </a:lnTo>
                  <a:lnTo>
                    <a:pt x="5047" y="1559"/>
                  </a:lnTo>
                  <a:lnTo>
                    <a:pt x="5061" y="1562"/>
                  </a:lnTo>
                  <a:lnTo>
                    <a:pt x="5076" y="1569"/>
                  </a:lnTo>
                  <a:lnTo>
                    <a:pt x="5090" y="1572"/>
                  </a:lnTo>
                  <a:lnTo>
                    <a:pt x="5104" y="1577"/>
                  </a:lnTo>
                  <a:lnTo>
                    <a:pt x="5119" y="1580"/>
                  </a:lnTo>
                  <a:lnTo>
                    <a:pt x="5133" y="1581"/>
                  </a:lnTo>
                  <a:lnTo>
                    <a:pt x="5148" y="1585"/>
                  </a:lnTo>
                  <a:lnTo>
                    <a:pt x="5162" y="1588"/>
                  </a:lnTo>
                  <a:lnTo>
                    <a:pt x="5177" y="1589"/>
                  </a:lnTo>
                  <a:lnTo>
                    <a:pt x="5191" y="1594"/>
                  </a:lnTo>
                  <a:lnTo>
                    <a:pt x="5206" y="1594"/>
                  </a:lnTo>
                  <a:lnTo>
                    <a:pt x="5220" y="1597"/>
                  </a:lnTo>
                  <a:lnTo>
                    <a:pt x="5235" y="1600"/>
                  </a:lnTo>
                  <a:lnTo>
                    <a:pt x="5249" y="1601"/>
                  </a:lnTo>
                  <a:lnTo>
                    <a:pt x="5264" y="1605"/>
                  </a:lnTo>
                  <a:lnTo>
                    <a:pt x="5278" y="1606"/>
                  </a:lnTo>
                  <a:lnTo>
                    <a:pt x="5292" y="1608"/>
                  </a:lnTo>
                  <a:lnTo>
                    <a:pt x="5307" y="1610"/>
                  </a:lnTo>
                  <a:lnTo>
                    <a:pt x="5321" y="1613"/>
                  </a:lnTo>
                  <a:lnTo>
                    <a:pt x="5336" y="1612"/>
                  </a:lnTo>
                  <a:lnTo>
                    <a:pt x="5350" y="1615"/>
                  </a:lnTo>
                  <a:lnTo>
                    <a:pt x="5365" y="1616"/>
                  </a:lnTo>
                  <a:lnTo>
                    <a:pt x="5379" y="1620"/>
                  </a:lnTo>
                  <a:lnTo>
                    <a:pt x="5394" y="1621"/>
                  </a:lnTo>
                  <a:lnTo>
                    <a:pt x="5408" y="1624"/>
                  </a:lnTo>
                  <a:lnTo>
                    <a:pt x="5423" y="1624"/>
                  </a:lnTo>
                  <a:lnTo>
                    <a:pt x="5437" y="1625"/>
                  </a:lnTo>
                  <a:lnTo>
                    <a:pt x="5452" y="1628"/>
                  </a:lnTo>
                  <a:lnTo>
                    <a:pt x="5466" y="1630"/>
                  </a:lnTo>
                  <a:lnTo>
                    <a:pt x="5480" y="1630"/>
                  </a:lnTo>
                  <a:lnTo>
                    <a:pt x="5495" y="1631"/>
                  </a:lnTo>
                  <a:lnTo>
                    <a:pt x="5509" y="1634"/>
                  </a:lnTo>
                  <a:lnTo>
                    <a:pt x="5524" y="1634"/>
                  </a:lnTo>
                  <a:lnTo>
                    <a:pt x="5538" y="1635"/>
                  </a:lnTo>
                  <a:lnTo>
                    <a:pt x="5553" y="1636"/>
                  </a:lnTo>
                  <a:lnTo>
                    <a:pt x="5567" y="1637"/>
                  </a:lnTo>
                  <a:lnTo>
                    <a:pt x="5582" y="1639"/>
                  </a:lnTo>
                  <a:lnTo>
                    <a:pt x="5596" y="1638"/>
                  </a:lnTo>
                  <a:lnTo>
                    <a:pt x="5611" y="1639"/>
                  </a:lnTo>
                  <a:lnTo>
                    <a:pt x="5625" y="1640"/>
                  </a:lnTo>
                  <a:lnTo>
                    <a:pt x="5640" y="1641"/>
                  </a:lnTo>
                  <a:lnTo>
                    <a:pt x="5654" y="1643"/>
                  </a:lnTo>
                  <a:lnTo>
                    <a:pt x="5668" y="1645"/>
                  </a:lnTo>
                  <a:lnTo>
                    <a:pt x="5683" y="1645"/>
                  </a:lnTo>
                  <a:lnTo>
                    <a:pt x="5697" y="1646"/>
                  </a:lnTo>
                  <a:lnTo>
                    <a:pt x="5712" y="1647"/>
                  </a:lnTo>
                  <a:lnTo>
                    <a:pt x="5726" y="1649"/>
                  </a:lnTo>
                  <a:lnTo>
                    <a:pt x="5741" y="1650"/>
                  </a:lnTo>
                  <a:lnTo>
                    <a:pt x="5755" y="1652"/>
                  </a:lnTo>
                  <a:lnTo>
                    <a:pt x="5770" y="1653"/>
                  </a:lnTo>
                  <a:lnTo>
                    <a:pt x="5784" y="1653"/>
                  </a:lnTo>
                  <a:lnTo>
                    <a:pt x="5799" y="1655"/>
                  </a:lnTo>
                  <a:lnTo>
                    <a:pt x="5813" y="1656"/>
                  </a:lnTo>
                  <a:lnTo>
                    <a:pt x="5828" y="1654"/>
                  </a:lnTo>
                  <a:lnTo>
                    <a:pt x="5842" y="1655"/>
                  </a:lnTo>
                  <a:lnTo>
                    <a:pt x="5856" y="1655"/>
                  </a:lnTo>
                  <a:lnTo>
                    <a:pt x="5871" y="1657"/>
                  </a:lnTo>
                  <a:lnTo>
                    <a:pt x="5885" y="1659"/>
                  </a:lnTo>
                  <a:lnTo>
                    <a:pt x="5900" y="1659"/>
                  </a:lnTo>
                  <a:lnTo>
                    <a:pt x="5914" y="1662"/>
                  </a:lnTo>
                  <a:lnTo>
                    <a:pt x="5929" y="1664"/>
                  </a:lnTo>
                  <a:lnTo>
                    <a:pt x="5943" y="1663"/>
                  </a:lnTo>
                  <a:lnTo>
                    <a:pt x="5958" y="1665"/>
                  </a:lnTo>
                  <a:lnTo>
                    <a:pt x="5972" y="1665"/>
                  </a:lnTo>
                  <a:lnTo>
                    <a:pt x="5987" y="1665"/>
                  </a:lnTo>
                  <a:lnTo>
                    <a:pt x="6001" y="1665"/>
                  </a:lnTo>
                  <a:lnTo>
                    <a:pt x="6016" y="1665"/>
                  </a:lnTo>
                  <a:lnTo>
                    <a:pt x="6030" y="1668"/>
                  </a:lnTo>
                  <a:lnTo>
                    <a:pt x="6044" y="1668"/>
                  </a:lnTo>
                  <a:lnTo>
                    <a:pt x="6059" y="1668"/>
                  </a:lnTo>
                  <a:lnTo>
                    <a:pt x="6073" y="1670"/>
                  </a:lnTo>
                  <a:lnTo>
                    <a:pt x="6088" y="1670"/>
                  </a:lnTo>
                  <a:lnTo>
                    <a:pt x="6102" y="1670"/>
                  </a:lnTo>
                  <a:lnTo>
                    <a:pt x="6117" y="1668"/>
                  </a:lnTo>
                  <a:lnTo>
                    <a:pt x="6131" y="1670"/>
                  </a:lnTo>
                  <a:lnTo>
                    <a:pt x="6146" y="1668"/>
                  </a:lnTo>
                  <a:lnTo>
                    <a:pt x="6160" y="1669"/>
                  </a:lnTo>
                  <a:lnTo>
                    <a:pt x="6175" y="1666"/>
                  </a:lnTo>
                  <a:lnTo>
                    <a:pt x="6189" y="1668"/>
                  </a:lnTo>
                  <a:lnTo>
                    <a:pt x="6204" y="1668"/>
                  </a:lnTo>
                  <a:lnTo>
                    <a:pt x="6218" y="1670"/>
                  </a:lnTo>
                  <a:lnTo>
                    <a:pt x="6232" y="1670"/>
                  </a:lnTo>
                  <a:lnTo>
                    <a:pt x="6247" y="1671"/>
                  </a:lnTo>
                  <a:lnTo>
                    <a:pt x="6261" y="1673"/>
                  </a:lnTo>
                  <a:lnTo>
                    <a:pt x="6276" y="1672"/>
                  </a:lnTo>
                  <a:lnTo>
                    <a:pt x="6290" y="1671"/>
                  </a:lnTo>
                  <a:lnTo>
                    <a:pt x="6305" y="1674"/>
                  </a:lnTo>
                  <a:lnTo>
                    <a:pt x="6319" y="1676"/>
                  </a:lnTo>
                  <a:lnTo>
                    <a:pt x="6334" y="1676"/>
                  </a:lnTo>
                  <a:lnTo>
                    <a:pt x="6348" y="1676"/>
                  </a:lnTo>
                  <a:lnTo>
                    <a:pt x="6363" y="1679"/>
                  </a:lnTo>
                  <a:lnTo>
                    <a:pt x="6377" y="1677"/>
                  </a:lnTo>
                  <a:lnTo>
                    <a:pt x="6392" y="1682"/>
                  </a:lnTo>
                  <a:lnTo>
                    <a:pt x="6406" y="1682"/>
                  </a:lnTo>
                  <a:lnTo>
                    <a:pt x="6420" y="1680"/>
                  </a:lnTo>
                  <a:lnTo>
                    <a:pt x="6435" y="1680"/>
                  </a:lnTo>
                  <a:lnTo>
                    <a:pt x="6449" y="1680"/>
                  </a:lnTo>
                  <a:lnTo>
                    <a:pt x="6464" y="1682"/>
                  </a:lnTo>
                  <a:lnTo>
                    <a:pt x="6478" y="1680"/>
                  </a:lnTo>
                  <a:lnTo>
                    <a:pt x="6493" y="1680"/>
                  </a:lnTo>
                  <a:lnTo>
                    <a:pt x="6507" y="1688"/>
                  </a:lnTo>
                  <a:lnTo>
                    <a:pt x="6522" y="1683"/>
                  </a:lnTo>
                  <a:lnTo>
                    <a:pt x="6536" y="1685"/>
                  </a:lnTo>
                  <a:lnTo>
                    <a:pt x="6551" y="1684"/>
                  </a:lnTo>
                  <a:lnTo>
                    <a:pt x="6565" y="1686"/>
                  </a:lnTo>
                  <a:lnTo>
                    <a:pt x="6580" y="1687"/>
                  </a:lnTo>
                  <a:lnTo>
                    <a:pt x="6594" y="1692"/>
                  </a:lnTo>
                  <a:lnTo>
                    <a:pt x="6608" y="1690"/>
                  </a:lnTo>
                  <a:lnTo>
                    <a:pt x="6623" y="1689"/>
                  </a:lnTo>
                  <a:lnTo>
                    <a:pt x="6637" y="1689"/>
                  </a:lnTo>
                  <a:lnTo>
                    <a:pt x="6652" y="1694"/>
                  </a:lnTo>
                  <a:lnTo>
                    <a:pt x="6666" y="1692"/>
                  </a:lnTo>
                  <a:lnTo>
                    <a:pt x="6681" y="1691"/>
                  </a:lnTo>
                  <a:lnTo>
                    <a:pt x="6695" y="1694"/>
                  </a:lnTo>
                  <a:lnTo>
                    <a:pt x="6710" y="1693"/>
                  </a:lnTo>
                  <a:lnTo>
                    <a:pt x="6724" y="1695"/>
                  </a:lnTo>
                  <a:lnTo>
                    <a:pt x="6739" y="1699"/>
                  </a:lnTo>
                  <a:lnTo>
                    <a:pt x="6753" y="1699"/>
                  </a:lnTo>
                  <a:lnTo>
                    <a:pt x="6768" y="1698"/>
                  </a:lnTo>
                  <a:lnTo>
                    <a:pt x="6782" y="1698"/>
                  </a:lnTo>
                  <a:lnTo>
                    <a:pt x="6796" y="1698"/>
                  </a:lnTo>
                  <a:lnTo>
                    <a:pt x="6811" y="1698"/>
                  </a:lnTo>
                  <a:lnTo>
                    <a:pt x="6825" y="1699"/>
                  </a:lnTo>
                  <a:lnTo>
                    <a:pt x="6840" y="1719"/>
                  </a:lnTo>
                  <a:lnTo>
                    <a:pt x="6854" y="1723"/>
                  </a:lnTo>
                  <a:lnTo>
                    <a:pt x="6869" y="1732"/>
                  </a:lnTo>
                  <a:lnTo>
                    <a:pt x="6883" y="1730"/>
                  </a:lnTo>
                  <a:lnTo>
                    <a:pt x="6898" y="1720"/>
                  </a:lnTo>
                  <a:lnTo>
                    <a:pt x="6912" y="1717"/>
                  </a:lnTo>
                  <a:lnTo>
                    <a:pt x="6927" y="1716"/>
                  </a:lnTo>
                  <a:lnTo>
                    <a:pt x="6941" y="1710"/>
                  </a:lnTo>
                  <a:lnTo>
                    <a:pt x="6956" y="1704"/>
                  </a:lnTo>
                  <a:lnTo>
                    <a:pt x="6970" y="1699"/>
                  </a:lnTo>
                  <a:lnTo>
                    <a:pt x="6984" y="1696"/>
                  </a:lnTo>
                  <a:lnTo>
                    <a:pt x="6999" y="1694"/>
                  </a:lnTo>
                  <a:lnTo>
                    <a:pt x="7013" y="1693"/>
                  </a:lnTo>
                  <a:lnTo>
                    <a:pt x="7028" y="1696"/>
                  </a:lnTo>
                  <a:lnTo>
                    <a:pt x="7042" y="1700"/>
                  </a:lnTo>
                  <a:lnTo>
                    <a:pt x="7057" y="1701"/>
                  </a:lnTo>
                  <a:lnTo>
                    <a:pt x="7071" y="1702"/>
                  </a:lnTo>
                  <a:lnTo>
                    <a:pt x="7086" y="1704"/>
                  </a:lnTo>
                  <a:lnTo>
                    <a:pt x="7100" y="1705"/>
                  </a:lnTo>
                  <a:lnTo>
                    <a:pt x="7115" y="1706"/>
                  </a:lnTo>
                  <a:lnTo>
                    <a:pt x="7129" y="1705"/>
                  </a:lnTo>
                  <a:lnTo>
                    <a:pt x="7144" y="1707"/>
                  </a:lnTo>
                  <a:lnTo>
                    <a:pt x="7158" y="1707"/>
                  </a:lnTo>
                  <a:lnTo>
                    <a:pt x="7172" y="1708"/>
                  </a:lnTo>
                  <a:lnTo>
                    <a:pt x="7187" y="1709"/>
                  </a:lnTo>
                  <a:lnTo>
                    <a:pt x="7201" y="1710"/>
                  </a:lnTo>
                  <a:lnTo>
                    <a:pt x="7216" y="1714"/>
                  </a:lnTo>
                  <a:lnTo>
                    <a:pt x="7230" y="1713"/>
                  </a:lnTo>
                  <a:lnTo>
                    <a:pt x="7245" y="1713"/>
                  </a:lnTo>
                  <a:lnTo>
                    <a:pt x="7259" y="1715"/>
                  </a:lnTo>
                  <a:lnTo>
                    <a:pt x="7274" y="1716"/>
                  </a:lnTo>
                  <a:lnTo>
                    <a:pt x="7288" y="1716"/>
                  </a:lnTo>
                  <a:lnTo>
                    <a:pt x="7303" y="1719"/>
                  </a:lnTo>
                  <a:lnTo>
                    <a:pt x="7317" y="1717"/>
                  </a:lnTo>
                  <a:lnTo>
                    <a:pt x="7332" y="1715"/>
                  </a:lnTo>
                  <a:lnTo>
                    <a:pt x="7346" y="1719"/>
                  </a:lnTo>
                  <a:lnTo>
                    <a:pt x="7360" y="1719"/>
                  </a:lnTo>
                  <a:lnTo>
                    <a:pt x="7375" y="1719"/>
                  </a:lnTo>
                  <a:lnTo>
                    <a:pt x="7389" y="1720"/>
                  </a:lnTo>
                  <a:lnTo>
                    <a:pt x="7404" y="1720"/>
                  </a:lnTo>
                  <a:lnTo>
                    <a:pt x="7418" y="1720"/>
                  </a:lnTo>
                  <a:lnTo>
                    <a:pt x="7433" y="1722"/>
                  </a:lnTo>
                  <a:lnTo>
                    <a:pt x="7447" y="1722"/>
                  </a:lnTo>
                  <a:lnTo>
                    <a:pt x="7462" y="1723"/>
                  </a:lnTo>
                  <a:lnTo>
                    <a:pt x="7476" y="1721"/>
                  </a:lnTo>
                  <a:lnTo>
                    <a:pt x="7491" y="1720"/>
                  </a:lnTo>
                  <a:lnTo>
                    <a:pt x="7505" y="1720"/>
                  </a:lnTo>
                  <a:lnTo>
                    <a:pt x="7520" y="1723"/>
                  </a:lnTo>
                  <a:lnTo>
                    <a:pt x="7534" y="1725"/>
                  </a:lnTo>
                  <a:lnTo>
                    <a:pt x="7549" y="1723"/>
                  </a:lnTo>
                </a:path>
              </a:pathLst>
            </a:cu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35609" tIns="17805" rIns="35609" bIns="17805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>
                <a:highlight>
                  <a:srgbClr val="000000"/>
                </a:highlight>
              </a:endParaRPr>
            </a:p>
          </p:txBody>
        </p:sp>
        <p:sp>
          <p:nvSpPr>
            <p:cNvPr id="88" name="Freeform 169">
              <a:extLst>
                <a:ext uri="{FF2B5EF4-FFF2-40B4-BE49-F238E27FC236}">
                  <a16:creationId xmlns:a16="http://schemas.microsoft.com/office/drawing/2014/main" id="{56B73A07-3A70-4490-836B-01A1D7949B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5201" y="6853964"/>
              <a:ext cx="1793053" cy="1279821"/>
            </a:xfrm>
            <a:custGeom>
              <a:avLst/>
              <a:gdLst>
                <a:gd name="T0" fmla="*/ 107 w 7549"/>
                <a:gd name="T1" fmla="*/ 1580 h 1583"/>
                <a:gd name="T2" fmla="*/ 235 w 7549"/>
                <a:gd name="T3" fmla="*/ 1577 h 1583"/>
                <a:gd name="T4" fmla="*/ 364 w 7549"/>
                <a:gd name="T5" fmla="*/ 1580 h 1583"/>
                <a:gd name="T6" fmla="*/ 493 w 7549"/>
                <a:gd name="T7" fmla="*/ 1580 h 1583"/>
                <a:gd name="T8" fmla="*/ 621 w 7549"/>
                <a:gd name="T9" fmla="*/ 1582 h 1583"/>
                <a:gd name="T10" fmla="*/ 750 w 7549"/>
                <a:gd name="T11" fmla="*/ 1577 h 1583"/>
                <a:gd name="T12" fmla="*/ 879 w 7549"/>
                <a:gd name="T13" fmla="*/ 1579 h 1583"/>
                <a:gd name="T14" fmla="*/ 1007 w 7549"/>
                <a:gd name="T15" fmla="*/ 1582 h 1583"/>
                <a:gd name="T16" fmla="*/ 1136 w 7549"/>
                <a:gd name="T17" fmla="*/ 1580 h 1583"/>
                <a:gd name="T18" fmla="*/ 1265 w 7549"/>
                <a:gd name="T19" fmla="*/ 1581 h 1583"/>
                <a:gd name="T20" fmla="*/ 1393 w 7549"/>
                <a:gd name="T21" fmla="*/ 1530 h 1583"/>
                <a:gd name="T22" fmla="*/ 1522 w 7549"/>
                <a:gd name="T23" fmla="*/ 1022 h 1583"/>
                <a:gd name="T24" fmla="*/ 1651 w 7549"/>
                <a:gd name="T25" fmla="*/ 726 h 1583"/>
                <a:gd name="T26" fmla="*/ 1780 w 7549"/>
                <a:gd name="T27" fmla="*/ 619 h 1583"/>
                <a:gd name="T28" fmla="*/ 1908 w 7549"/>
                <a:gd name="T29" fmla="*/ 522 h 1583"/>
                <a:gd name="T30" fmla="*/ 2037 w 7549"/>
                <a:gd name="T31" fmla="*/ 432 h 1583"/>
                <a:gd name="T32" fmla="*/ 2166 w 7549"/>
                <a:gd name="T33" fmla="*/ 345 h 1583"/>
                <a:gd name="T34" fmla="*/ 2294 w 7549"/>
                <a:gd name="T35" fmla="*/ 271 h 1583"/>
                <a:gd name="T36" fmla="*/ 2423 w 7549"/>
                <a:gd name="T37" fmla="*/ 218 h 1583"/>
                <a:gd name="T38" fmla="*/ 2552 w 7549"/>
                <a:gd name="T39" fmla="*/ 181 h 1583"/>
                <a:gd name="T40" fmla="*/ 2680 w 7549"/>
                <a:gd name="T41" fmla="*/ 149 h 1583"/>
                <a:gd name="T42" fmla="*/ 2809 w 7549"/>
                <a:gd name="T43" fmla="*/ 129 h 1583"/>
                <a:gd name="T44" fmla="*/ 2938 w 7549"/>
                <a:gd name="T45" fmla="*/ 101 h 1583"/>
                <a:gd name="T46" fmla="*/ 3066 w 7549"/>
                <a:gd name="T47" fmla="*/ 83 h 1583"/>
                <a:gd name="T48" fmla="*/ 3195 w 7549"/>
                <a:gd name="T49" fmla="*/ 72 h 1583"/>
                <a:gd name="T50" fmla="*/ 3324 w 7549"/>
                <a:gd name="T51" fmla="*/ 60 h 1583"/>
                <a:gd name="T52" fmla="*/ 3452 w 7549"/>
                <a:gd name="T53" fmla="*/ 52 h 1583"/>
                <a:gd name="T54" fmla="*/ 3581 w 7549"/>
                <a:gd name="T55" fmla="*/ 43 h 1583"/>
                <a:gd name="T56" fmla="*/ 3710 w 7549"/>
                <a:gd name="T57" fmla="*/ 37 h 1583"/>
                <a:gd name="T58" fmla="*/ 3838 w 7549"/>
                <a:gd name="T59" fmla="*/ 27 h 1583"/>
                <a:gd name="T60" fmla="*/ 3967 w 7549"/>
                <a:gd name="T61" fmla="*/ 27 h 1583"/>
                <a:gd name="T62" fmla="*/ 4096 w 7549"/>
                <a:gd name="T63" fmla="*/ 18 h 1583"/>
                <a:gd name="T64" fmla="*/ 4224 w 7549"/>
                <a:gd name="T65" fmla="*/ 11 h 1583"/>
                <a:gd name="T66" fmla="*/ 4353 w 7549"/>
                <a:gd name="T67" fmla="*/ 7 h 1583"/>
                <a:gd name="T68" fmla="*/ 4482 w 7549"/>
                <a:gd name="T69" fmla="*/ 1 h 1583"/>
                <a:gd name="T70" fmla="*/ 4610 w 7549"/>
                <a:gd name="T71" fmla="*/ 1 h 1583"/>
                <a:gd name="T72" fmla="*/ 4739 w 7549"/>
                <a:gd name="T73" fmla="*/ 16 h 1583"/>
                <a:gd name="T74" fmla="*/ 4868 w 7549"/>
                <a:gd name="T75" fmla="*/ 281 h 1583"/>
                <a:gd name="T76" fmla="*/ 4996 w 7549"/>
                <a:gd name="T77" fmla="*/ 729 h 1583"/>
                <a:gd name="T78" fmla="*/ 5125 w 7549"/>
                <a:gd name="T79" fmla="*/ 1032 h 1583"/>
                <a:gd name="T80" fmla="*/ 5254 w 7549"/>
                <a:gd name="T81" fmla="*/ 1187 h 1583"/>
                <a:gd name="T82" fmla="*/ 5382 w 7549"/>
                <a:gd name="T83" fmla="*/ 1287 h 1583"/>
                <a:gd name="T84" fmla="*/ 5511 w 7549"/>
                <a:gd name="T85" fmla="*/ 1348 h 1583"/>
                <a:gd name="T86" fmla="*/ 5640 w 7549"/>
                <a:gd name="T87" fmla="*/ 1390 h 1583"/>
                <a:gd name="T88" fmla="*/ 5768 w 7549"/>
                <a:gd name="T89" fmla="*/ 1421 h 1583"/>
                <a:gd name="T90" fmla="*/ 5897 w 7549"/>
                <a:gd name="T91" fmla="*/ 1440 h 1583"/>
                <a:gd name="T92" fmla="*/ 6026 w 7549"/>
                <a:gd name="T93" fmla="*/ 1455 h 1583"/>
                <a:gd name="T94" fmla="*/ 6155 w 7549"/>
                <a:gd name="T95" fmla="*/ 1470 h 1583"/>
                <a:gd name="T96" fmla="*/ 6283 w 7549"/>
                <a:gd name="T97" fmla="*/ 1479 h 1583"/>
                <a:gd name="T98" fmla="*/ 6412 w 7549"/>
                <a:gd name="T99" fmla="*/ 1488 h 1583"/>
                <a:gd name="T100" fmla="*/ 6541 w 7549"/>
                <a:gd name="T101" fmla="*/ 1496 h 1583"/>
                <a:gd name="T102" fmla="*/ 6669 w 7549"/>
                <a:gd name="T103" fmla="*/ 1506 h 1583"/>
                <a:gd name="T104" fmla="*/ 6798 w 7549"/>
                <a:gd name="T105" fmla="*/ 1512 h 1583"/>
                <a:gd name="T106" fmla="*/ 6927 w 7549"/>
                <a:gd name="T107" fmla="*/ 1518 h 1583"/>
                <a:gd name="T108" fmla="*/ 7055 w 7549"/>
                <a:gd name="T109" fmla="*/ 1525 h 1583"/>
                <a:gd name="T110" fmla="*/ 7184 w 7549"/>
                <a:gd name="T111" fmla="*/ 1531 h 1583"/>
                <a:gd name="T112" fmla="*/ 7313 w 7549"/>
                <a:gd name="T113" fmla="*/ 1534 h 1583"/>
                <a:gd name="T114" fmla="*/ 7441 w 7549"/>
                <a:gd name="T115" fmla="*/ 1541 h 15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7549" h="1583">
                  <a:moveTo>
                    <a:pt x="0" y="1578"/>
                  </a:moveTo>
                  <a:lnTo>
                    <a:pt x="21" y="1577"/>
                  </a:lnTo>
                  <a:lnTo>
                    <a:pt x="42" y="1578"/>
                  </a:lnTo>
                  <a:lnTo>
                    <a:pt x="64" y="1580"/>
                  </a:lnTo>
                  <a:lnTo>
                    <a:pt x="85" y="1578"/>
                  </a:lnTo>
                  <a:lnTo>
                    <a:pt x="107" y="1580"/>
                  </a:lnTo>
                  <a:lnTo>
                    <a:pt x="128" y="1578"/>
                  </a:lnTo>
                  <a:lnTo>
                    <a:pt x="150" y="1578"/>
                  </a:lnTo>
                  <a:lnTo>
                    <a:pt x="171" y="1580"/>
                  </a:lnTo>
                  <a:lnTo>
                    <a:pt x="193" y="1580"/>
                  </a:lnTo>
                  <a:lnTo>
                    <a:pt x="214" y="1580"/>
                  </a:lnTo>
                  <a:lnTo>
                    <a:pt x="235" y="1577"/>
                  </a:lnTo>
                  <a:lnTo>
                    <a:pt x="257" y="1577"/>
                  </a:lnTo>
                  <a:lnTo>
                    <a:pt x="278" y="1581"/>
                  </a:lnTo>
                  <a:lnTo>
                    <a:pt x="300" y="1577"/>
                  </a:lnTo>
                  <a:lnTo>
                    <a:pt x="321" y="1581"/>
                  </a:lnTo>
                  <a:lnTo>
                    <a:pt x="343" y="1580"/>
                  </a:lnTo>
                  <a:lnTo>
                    <a:pt x="364" y="1580"/>
                  </a:lnTo>
                  <a:lnTo>
                    <a:pt x="386" y="1577"/>
                  </a:lnTo>
                  <a:lnTo>
                    <a:pt x="407" y="1579"/>
                  </a:lnTo>
                  <a:lnTo>
                    <a:pt x="428" y="1579"/>
                  </a:lnTo>
                  <a:lnTo>
                    <a:pt x="450" y="1580"/>
                  </a:lnTo>
                  <a:lnTo>
                    <a:pt x="471" y="1580"/>
                  </a:lnTo>
                  <a:lnTo>
                    <a:pt x="493" y="1580"/>
                  </a:lnTo>
                  <a:lnTo>
                    <a:pt x="514" y="1580"/>
                  </a:lnTo>
                  <a:lnTo>
                    <a:pt x="536" y="1581"/>
                  </a:lnTo>
                  <a:lnTo>
                    <a:pt x="557" y="1580"/>
                  </a:lnTo>
                  <a:lnTo>
                    <a:pt x="579" y="1578"/>
                  </a:lnTo>
                  <a:lnTo>
                    <a:pt x="600" y="1580"/>
                  </a:lnTo>
                  <a:lnTo>
                    <a:pt x="621" y="1582"/>
                  </a:lnTo>
                  <a:lnTo>
                    <a:pt x="643" y="1579"/>
                  </a:lnTo>
                  <a:lnTo>
                    <a:pt x="664" y="1580"/>
                  </a:lnTo>
                  <a:lnTo>
                    <a:pt x="686" y="1582"/>
                  </a:lnTo>
                  <a:lnTo>
                    <a:pt x="707" y="1583"/>
                  </a:lnTo>
                  <a:lnTo>
                    <a:pt x="729" y="1580"/>
                  </a:lnTo>
                  <a:lnTo>
                    <a:pt x="750" y="1577"/>
                  </a:lnTo>
                  <a:lnTo>
                    <a:pt x="772" y="1579"/>
                  </a:lnTo>
                  <a:lnTo>
                    <a:pt x="793" y="1580"/>
                  </a:lnTo>
                  <a:lnTo>
                    <a:pt x="814" y="1579"/>
                  </a:lnTo>
                  <a:lnTo>
                    <a:pt x="836" y="1579"/>
                  </a:lnTo>
                  <a:lnTo>
                    <a:pt x="857" y="1581"/>
                  </a:lnTo>
                  <a:lnTo>
                    <a:pt x="879" y="1579"/>
                  </a:lnTo>
                  <a:lnTo>
                    <a:pt x="900" y="1579"/>
                  </a:lnTo>
                  <a:lnTo>
                    <a:pt x="922" y="1579"/>
                  </a:lnTo>
                  <a:lnTo>
                    <a:pt x="943" y="1579"/>
                  </a:lnTo>
                  <a:lnTo>
                    <a:pt x="965" y="1582"/>
                  </a:lnTo>
                  <a:lnTo>
                    <a:pt x="986" y="1580"/>
                  </a:lnTo>
                  <a:lnTo>
                    <a:pt x="1007" y="1582"/>
                  </a:lnTo>
                  <a:lnTo>
                    <a:pt x="1029" y="1580"/>
                  </a:lnTo>
                  <a:lnTo>
                    <a:pt x="1050" y="1580"/>
                  </a:lnTo>
                  <a:lnTo>
                    <a:pt x="1072" y="1582"/>
                  </a:lnTo>
                  <a:lnTo>
                    <a:pt x="1093" y="1580"/>
                  </a:lnTo>
                  <a:lnTo>
                    <a:pt x="1115" y="1580"/>
                  </a:lnTo>
                  <a:lnTo>
                    <a:pt x="1136" y="1580"/>
                  </a:lnTo>
                  <a:lnTo>
                    <a:pt x="1158" y="1582"/>
                  </a:lnTo>
                  <a:lnTo>
                    <a:pt x="1179" y="1577"/>
                  </a:lnTo>
                  <a:lnTo>
                    <a:pt x="1200" y="1580"/>
                  </a:lnTo>
                  <a:lnTo>
                    <a:pt x="1222" y="1579"/>
                  </a:lnTo>
                  <a:lnTo>
                    <a:pt x="1243" y="1580"/>
                  </a:lnTo>
                  <a:lnTo>
                    <a:pt x="1265" y="1581"/>
                  </a:lnTo>
                  <a:lnTo>
                    <a:pt x="1286" y="1582"/>
                  </a:lnTo>
                  <a:lnTo>
                    <a:pt x="1308" y="1581"/>
                  </a:lnTo>
                  <a:lnTo>
                    <a:pt x="1329" y="1575"/>
                  </a:lnTo>
                  <a:lnTo>
                    <a:pt x="1351" y="1569"/>
                  </a:lnTo>
                  <a:lnTo>
                    <a:pt x="1372" y="1554"/>
                  </a:lnTo>
                  <a:lnTo>
                    <a:pt x="1393" y="1530"/>
                  </a:lnTo>
                  <a:lnTo>
                    <a:pt x="1415" y="1486"/>
                  </a:lnTo>
                  <a:lnTo>
                    <a:pt x="1436" y="1416"/>
                  </a:lnTo>
                  <a:lnTo>
                    <a:pt x="1458" y="1313"/>
                  </a:lnTo>
                  <a:lnTo>
                    <a:pt x="1479" y="1215"/>
                  </a:lnTo>
                  <a:lnTo>
                    <a:pt x="1501" y="1122"/>
                  </a:lnTo>
                  <a:lnTo>
                    <a:pt x="1522" y="1022"/>
                  </a:lnTo>
                  <a:lnTo>
                    <a:pt x="1544" y="962"/>
                  </a:lnTo>
                  <a:lnTo>
                    <a:pt x="1565" y="876"/>
                  </a:lnTo>
                  <a:lnTo>
                    <a:pt x="1587" y="827"/>
                  </a:lnTo>
                  <a:lnTo>
                    <a:pt x="1608" y="786"/>
                  </a:lnTo>
                  <a:lnTo>
                    <a:pt x="1629" y="743"/>
                  </a:lnTo>
                  <a:lnTo>
                    <a:pt x="1651" y="726"/>
                  </a:lnTo>
                  <a:lnTo>
                    <a:pt x="1672" y="705"/>
                  </a:lnTo>
                  <a:lnTo>
                    <a:pt x="1694" y="698"/>
                  </a:lnTo>
                  <a:lnTo>
                    <a:pt x="1715" y="682"/>
                  </a:lnTo>
                  <a:lnTo>
                    <a:pt x="1737" y="665"/>
                  </a:lnTo>
                  <a:lnTo>
                    <a:pt x="1758" y="640"/>
                  </a:lnTo>
                  <a:lnTo>
                    <a:pt x="1780" y="619"/>
                  </a:lnTo>
                  <a:lnTo>
                    <a:pt x="1801" y="607"/>
                  </a:lnTo>
                  <a:lnTo>
                    <a:pt x="1822" y="596"/>
                  </a:lnTo>
                  <a:lnTo>
                    <a:pt x="1844" y="586"/>
                  </a:lnTo>
                  <a:lnTo>
                    <a:pt x="1865" y="561"/>
                  </a:lnTo>
                  <a:lnTo>
                    <a:pt x="1887" y="547"/>
                  </a:lnTo>
                  <a:lnTo>
                    <a:pt x="1908" y="522"/>
                  </a:lnTo>
                  <a:lnTo>
                    <a:pt x="1930" y="511"/>
                  </a:lnTo>
                  <a:lnTo>
                    <a:pt x="1951" y="500"/>
                  </a:lnTo>
                  <a:lnTo>
                    <a:pt x="1973" y="480"/>
                  </a:lnTo>
                  <a:lnTo>
                    <a:pt x="1994" y="466"/>
                  </a:lnTo>
                  <a:lnTo>
                    <a:pt x="2015" y="447"/>
                  </a:lnTo>
                  <a:lnTo>
                    <a:pt x="2037" y="432"/>
                  </a:lnTo>
                  <a:lnTo>
                    <a:pt x="2058" y="419"/>
                  </a:lnTo>
                  <a:lnTo>
                    <a:pt x="2080" y="400"/>
                  </a:lnTo>
                  <a:lnTo>
                    <a:pt x="2101" y="382"/>
                  </a:lnTo>
                  <a:lnTo>
                    <a:pt x="2123" y="366"/>
                  </a:lnTo>
                  <a:lnTo>
                    <a:pt x="2144" y="356"/>
                  </a:lnTo>
                  <a:lnTo>
                    <a:pt x="2166" y="345"/>
                  </a:lnTo>
                  <a:lnTo>
                    <a:pt x="2187" y="332"/>
                  </a:lnTo>
                  <a:lnTo>
                    <a:pt x="2208" y="326"/>
                  </a:lnTo>
                  <a:lnTo>
                    <a:pt x="2230" y="312"/>
                  </a:lnTo>
                  <a:lnTo>
                    <a:pt x="2251" y="301"/>
                  </a:lnTo>
                  <a:lnTo>
                    <a:pt x="2273" y="285"/>
                  </a:lnTo>
                  <a:lnTo>
                    <a:pt x="2294" y="271"/>
                  </a:lnTo>
                  <a:lnTo>
                    <a:pt x="2316" y="261"/>
                  </a:lnTo>
                  <a:lnTo>
                    <a:pt x="2337" y="252"/>
                  </a:lnTo>
                  <a:lnTo>
                    <a:pt x="2359" y="247"/>
                  </a:lnTo>
                  <a:lnTo>
                    <a:pt x="2380" y="242"/>
                  </a:lnTo>
                  <a:lnTo>
                    <a:pt x="2401" y="227"/>
                  </a:lnTo>
                  <a:lnTo>
                    <a:pt x="2423" y="218"/>
                  </a:lnTo>
                  <a:lnTo>
                    <a:pt x="2444" y="206"/>
                  </a:lnTo>
                  <a:lnTo>
                    <a:pt x="2466" y="197"/>
                  </a:lnTo>
                  <a:lnTo>
                    <a:pt x="2487" y="192"/>
                  </a:lnTo>
                  <a:lnTo>
                    <a:pt x="2509" y="184"/>
                  </a:lnTo>
                  <a:lnTo>
                    <a:pt x="2530" y="184"/>
                  </a:lnTo>
                  <a:lnTo>
                    <a:pt x="2552" y="181"/>
                  </a:lnTo>
                  <a:lnTo>
                    <a:pt x="2573" y="181"/>
                  </a:lnTo>
                  <a:lnTo>
                    <a:pt x="2594" y="180"/>
                  </a:lnTo>
                  <a:lnTo>
                    <a:pt x="2616" y="176"/>
                  </a:lnTo>
                  <a:lnTo>
                    <a:pt x="2637" y="168"/>
                  </a:lnTo>
                  <a:lnTo>
                    <a:pt x="2659" y="160"/>
                  </a:lnTo>
                  <a:lnTo>
                    <a:pt x="2680" y="149"/>
                  </a:lnTo>
                  <a:lnTo>
                    <a:pt x="2702" y="145"/>
                  </a:lnTo>
                  <a:lnTo>
                    <a:pt x="2723" y="144"/>
                  </a:lnTo>
                  <a:lnTo>
                    <a:pt x="2745" y="144"/>
                  </a:lnTo>
                  <a:lnTo>
                    <a:pt x="2766" y="141"/>
                  </a:lnTo>
                  <a:lnTo>
                    <a:pt x="2787" y="135"/>
                  </a:lnTo>
                  <a:lnTo>
                    <a:pt x="2809" y="129"/>
                  </a:lnTo>
                  <a:lnTo>
                    <a:pt x="2830" y="125"/>
                  </a:lnTo>
                  <a:lnTo>
                    <a:pt x="2852" y="118"/>
                  </a:lnTo>
                  <a:lnTo>
                    <a:pt x="2873" y="114"/>
                  </a:lnTo>
                  <a:lnTo>
                    <a:pt x="2895" y="112"/>
                  </a:lnTo>
                  <a:lnTo>
                    <a:pt x="2916" y="106"/>
                  </a:lnTo>
                  <a:lnTo>
                    <a:pt x="2938" y="101"/>
                  </a:lnTo>
                  <a:lnTo>
                    <a:pt x="2959" y="97"/>
                  </a:lnTo>
                  <a:lnTo>
                    <a:pt x="2980" y="94"/>
                  </a:lnTo>
                  <a:lnTo>
                    <a:pt x="3002" y="92"/>
                  </a:lnTo>
                  <a:lnTo>
                    <a:pt x="3023" y="90"/>
                  </a:lnTo>
                  <a:lnTo>
                    <a:pt x="3045" y="86"/>
                  </a:lnTo>
                  <a:lnTo>
                    <a:pt x="3066" y="83"/>
                  </a:lnTo>
                  <a:lnTo>
                    <a:pt x="3088" y="79"/>
                  </a:lnTo>
                  <a:lnTo>
                    <a:pt x="3109" y="80"/>
                  </a:lnTo>
                  <a:lnTo>
                    <a:pt x="3131" y="77"/>
                  </a:lnTo>
                  <a:lnTo>
                    <a:pt x="3152" y="72"/>
                  </a:lnTo>
                  <a:lnTo>
                    <a:pt x="3174" y="74"/>
                  </a:lnTo>
                  <a:lnTo>
                    <a:pt x="3195" y="72"/>
                  </a:lnTo>
                  <a:lnTo>
                    <a:pt x="3216" y="72"/>
                  </a:lnTo>
                  <a:lnTo>
                    <a:pt x="3238" y="69"/>
                  </a:lnTo>
                  <a:lnTo>
                    <a:pt x="3259" y="67"/>
                  </a:lnTo>
                  <a:lnTo>
                    <a:pt x="3281" y="65"/>
                  </a:lnTo>
                  <a:lnTo>
                    <a:pt x="3302" y="60"/>
                  </a:lnTo>
                  <a:lnTo>
                    <a:pt x="3324" y="60"/>
                  </a:lnTo>
                  <a:lnTo>
                    <a:pt x="3345" y="61"/>
                  </a:lnTo>
                  <a:lnTo>
                    <a:pt x="3367" y="61"/>
                  </a:lnTo>
                  <a:lnTo>
                    <a:pt x="3388" y="58"/>
                  </a:lnTo>
                  <a:lnTo>
                    <a:pt x="3409" y="53"/>
                  </a:lnTo>
                  <a:lnTo>
                    <a:pt x="3431" y="52"/>
                  </a:lnTo>
                  <a:lnTo>
                    <a:pt x="3452" y="52"/>
                  </a:lnTo>
                  <a:lnTo>
                    <a:pt x="3474" y="48"/>
                  </a:lnTo>
                  <a:lnTo>
                    <a:pt x="3495" y="46"/>
                  </a:lnTo>
                  <a:lnTo>
                    <a:pt x="3517" y="46"/>
                  </a:lnTo>
                  <a:lnTo>
                    <a:pt x="3538" y="43"/>
                  </a:lnTo>
                  <a:lnTo>
                    <a:pt x="3560" y="44"/>
                  </a:lnTo>
                  <a:lnTo>
                    <a:pt x="3581" y="43"/>
                  </a:lnTo>
                  <a:lnTo>
                    <a:pt x="3602" y="42"/>
                  </a:lnTo>
                  <a:lnTo>
                    <a:pt x="3624" y="41"/>
                  </a:lnTo>
                  <a:lnTo>
                    <a:pt x="3645" y="40"/>
                  </a:lnTo>
                  <a:lnTo>
                    <a:pt x="3667" y="42"/>
                  </a:lnTo>
                  <a:lnTo>
                    <a:pt x="3688" y="36"/>
                  </a:lnTo>
                  <a:lnTo>
                    <a:pt x="3710" y="37"/>
                  </a:lnTo>
                  <a:lnTo>
                    <a:pt x="3731" y="33"/>
                  </a:lnTo>
                  <a:lnTo>
                    <a:pt x="3753" y="33"/>
                  </a:lnTo>
                  <a:lnTo>
                    <a:pt x="3774" y="33"/>
                  </a:lnTo>
                  <a:lnTo>
                    <a:pt x="3795" y="30"/>
                  </a:lnTo>
                  <a:lnTo>
                    <a:pt x="3817" y="29"/>
                  </a:lnTo>
                  <a:lnTo>
                    <a:pt x="3838" y="27"/>
                  </a:lnTo>
                  <a:lnTo>
                    <a:pt x="3860" y="27"/>
                  </a:lnTo>
                  <a:lnTo>
                    <a:pt x="3881" y="26"/>
                  </a:lnTo>
                  <a:lnTo>
                    <a:pt x="3903" y="26"/>
                  </a:lnTo>
                  <a:lnTo>
                    <a:pt x="3924" y="26"/>
                  </a:lnTo>
                  <a:lnTo>
                    <a:pt x="3946" y="25"/>
                  </a:lnTo>
                  <a:lnTo>
                    <a:pt x="3967" y="27"/>
                  </a:lnTo>
                  <a:lnTo>
                    <a:pt x="3988" y="26"/>
                  </a:lnTo>
                  <a:lnTo>
                    <a:pt x="4010" y="22"/>
                  </a:lnTo>
                  <a:lnTo>
                    <a:pt x="4031" y="22"/>
                  </a:lnTo>
                  <a:lnTo>
                    <a:pt x="4053" y="20"/>
                  </a:lnTo>
                  <a:lnTo>
                    <a:pt x="4074" y="19"/>
                  </a:lnTo>
                  <a:lnTo>
                    <a:pt x="4096" y="18"/>
                  </a:lnTo>
                  <a:lnTo>
                    <a:pt x="4117" y="17"/>
                  </a:lnTo>
                  <a:lnTo>
                    <a:pt x="4139" y="17"/>
                  </a:lnTo>
                  <a:lnTo>
                    <a:pt x="4160" y="16"/>
                  </a:lnTo>
                  <a:lnTo>
                    <a:pt x="4181" y="16"/>
                  </a:lnTo>
                  <a:lnTo>
                    <a:pt x="4203" y="13"/>
                  </a:lnTo>
                  <a:lnTo>
                    <a:pt x="4224" y="11"/>
                  </a:lnTo>
                  <a:lnTo>
                    <a:pt x="4246" y="11"/>
                  </a:lnTo>
                  <a:lnTo>
                    <a:pt x="4267" y="12"/>
                  </a:lnTo>
                  <a:lnTo>
                    <a:pt x="4289" y="12"/>
                  </a:lnTo>
                  <a:lnTo>
                    <a:pt x="4310" y="10"/>
                  </a:lnTo>
                  <a:lnTo>
                    <a:pt x="4332" y="9"/>
                  </a:lnTo>
                  <a:lnTo>
                    <a:pt x="4353" y="7"/>
                  </a:lnTo>
                  <a:lnTo>
                    <a:pt x="4374" y="7"/>
                  </a:lnTo>
                  <a:lnTo>
                    <a:pt x="4396" y="4"/>
                  </a:lnTo>
                  <a:lnTo>
                    <a:pt x="4417" y="6"/>
                  </a:lnTo>
                  <a:lnTo>
                    <a:pt x="4439" y="3"/>
                  </a:lnTo>
                  <a:lnTo>
                    <a:pt x="4460" y="3"/>
                  </a:lnTo>
                  <a:lnTo>
                    <a:pt x="4482" y="1"/>
                  </a:lnTo>
                  <a:lnTo>
                    <a:pt x="4503" y="1"/>
                  </a:lnTo>
                  <a:lnTo>
                    <a:pt x="4525" y="3"/>
                  </a:lnTo>
                  <a:lnTo>
                    <a:pt x="4546" y="1"/>
                  </a:lnTo>
                  <a:lnTo>
                    <a:pt x="4568" y="4"/>
                  </a:lnTo>
                  <a:lnTo>
                    <a:pt x="4589" y="3"/>
                  </a:lnTo>
                  <a:lnTo>
                    <a:pt x="4610" y="1"/>
                  </a:lnTo>
                  <a:lnTo>
                    <a:pt x="4632" y="3"/>
                  </a:lnTo>
                  <a:lnTo>
                    <a:pt x="4653" y="1"/>
                  </a:lnTo>
                  <a:lnTo>
                    <a:pt x="4675" y="1"/>
                  </a:lnTo>
                  <a:lnTo>
                    <a:pt x="4696" y="0"/>
                  </a:lnTo>
                  <a:lnTo>
                    <a:pt x="4718" y="3"/>
                  </a:lnTo>
                  <a:lnTo>
                    <a:pt x="4739" y="16"/>
                  </a:lnTo>
                  <a:lnTo>
                    <a:pt x="4761" y="37"/>
                  </a:lnTo>
                  <a:lnTo>
                    <a:pt x="4782" y="66"/>
                  </a:lnTo>
                  <a:lnTo>
                    <a:pt x="4803" y="100"/>
                  </a:lnTo>
                  <a:lnTo>
                    <a:pt x="4825" y="144"/>
                  </a:lnTo>
                  <a:lnTo>
                    <a:pt x="4846" y="215"/>
                  </a:lnTo>
                  <a:lnTo>
                    <a:pt x="4868" y="281"/>
                  </a:lnTo>
                  <a:lnTo>
                    <a:pt x="4889" y="361"/>
                  </a:lnTo>
                  <a:lnTo>
                    <a:pt x="4911" y="454"/>
                  </a:lnTo>
                  <a:lnTo>
                    <a:pt x="4932" y="514"/>
                  </a:lnTo>
                  <a:lnTo>
                    <a:pt x="4954" y="604"/>
                  </a:lnTo>
                  <a:lnTo>
                    <a:pt x="4975" y="678"/>
                  </a:lnTo>
                  <a:lnTo>
                    <a:pt x="4996" y="729"/>
                  </a:lnTo>
                  <a:lnTo>
                    <a:pt x="5018" y="810"/>
                  </a:lnTo>
                  <a:lnTo>
                    <a:pt x="5039" y="862"/>
                  </a:lnTo>
                  <a:lnTo>
                    <a:pt x="5061" y="904"/>
                  </a:lnTo>
                  <a:lnTo>
                    <a:pt x="5082" y="951"/>
                  </a:lnTo>
                  <a:lnTo>
                    <a:pt x="5104" y="988"/>
                  </a:lnTo>
                  <a:lnTo>
                    <a:pt x="5125" y="1032"/>
                  </a:lnTo>
                  <a:lnTo>
                    <a:pt x="5147" y="1065"/>
                  </a:lnTo>
                  <a:lnTo>
                    <a:pt x="5168" y="1095"/>
                  </a:lnTo>
                  <a:lnTo>
                    <a:pt x="5189" y="1120"/>
                  </a:lnTo>
                  <a:lnTo>
                    <a:pt x="5211" y="1148"/>
                  </a:lnTo>
                  <a:lnTo>
                    <a:pt x="5232" y="1172"/>
                  </a:lnTo>
                  <a:lnTo>
                    <a:pt x="5254" y="1187"/>
                  </a:lnTo>
                  <a:lnTo>
                    <a:pt x="5275" y="1209"/>
                  </a:lnTo>
                  <a:lnTo>
                    <a:pt x="5297" y="1225"/>
                  </a:lnTo>
                  <a:lnTo>
                    <a:pt x="5318" y="1248"/>
                  </a:lnTo>
                  <a:lnTo>
                    <a:pt x="5340" y="1261"/>
                  </a:lnTo>
                  <a:lnTo>
                    <a:pt x="5361" y="1273"/>
                  </a:lnTo>
                  <a:lnTo>
                    <a:pt x="5382" y="1287"/>
                  </a:lnTo>
                  <a:lnTo>
                    <a:pt x="5404" y="1300"/>
                  </a:lnTo>
                  <a:lnTo>
                    <a:pt x="5425" y="1306"/>
                  </a:lnTo>
                  <a:lnTo>
                    <a:pt x="5447" y="1322"/>
                  </a:lnTo>
                  <a:lnTo>
                    <a:pt x="5468" y="1326"/>
                  </a:lnTo>
                  <a:lnTo>
                    <a:pt x="5490" y="1338"/>
                  </a:lnTo>
                  <a:lnTo>
                    <a:pt x="5511" y="1348"/>
                  </a:lnTo>
                  <a:lnTo>
                    <a:pt x="5533" y="1357"/>
                  </a:lnTo>
                  <a:lnTo>
                    <a:pt x="5554" y="1363"/>
                  </a:lnTo>
                  <a:lnTo>
                    <a:pt x="5575" y="1369"/>
                  </a:lnTo>
                  <a:lnTo>
                    <a:pt x="5597" y="1378"/>
                  </a:lnTo>
                  <a:lnTo>
                    <a:pt x="5618" y="1382"/>
                  </a:lnTo>
                  <a:lnTo>
                    <a:pt x="5640" y="1390"/>
                  </a:lnTo>
                  <a:lnTo>
                    <a:pt x="5661" y="1392"/>
                  </a:lnTo>
                  <a:lnTo>
                    <a:pt x="5683" y="1397"/>
                  </a:lnTo>
                  <a:lnTo>
                    <a:pt x="5704" y="1405"/>
                  </a:lnTo>
                  <a:lnTo>
                    <a:pt x="5726" y="1412"/>
                  </a:lnTo>
                  <a:lnTo>
                    <a:pt x="5747" y="1416"/>
                  </a:lnTo>
                  <a:lnTo>
                    <a:pt x="5768" y="1421"/>
                  </a:lnTo>
                  <a:lnTo>
                    <a:pt x="5790" y="1424"/>
                  </a:lnTo>
                  <a:lnTo>
                    <a:pt x="5811" y="1428"/>
                  </a:lnTo>
                  <a:lnTo>
                    <a:pt x="5833" y="1431"/>
                  </a:lnTo>
                  <a:lnTo>
                    <a:pt x="5854" y="1435"/>
                  </a:lnTo>
                  <a:lnTo>
                    <a:pt x="5876" y="1439"/>
                  </a:lnTo>
                  <a:lnTo>
                    <a:pt x="5897" y="1440"/>
                  </a:lnTo>
                  <a:lnTo>
                    <a:pt x="5919" y="1442"/>
                  </a:lnTo>
                  <a:lnTo>
                    <a:pt x="5940" y="1447"/>
                  </a:lnTo>
                  <a:lnTo>
                    <a:pt x="5961" y="1448"/>
                  </a:lnTo>
                  <a:lnTo>
                    <a:pt x="5983" y="1450"/>
                  </a:lnTo>
                  <a:lnTo>
                    <a:pt x="6004" y="1454"/>
                  </a:lnTo>
                  <a:lnTo>
                    <a:pt x="6026" y="1455"/>
                  </a:lnTo>
                  <a:lnTo>
                    <a:pt x="6047" y="1460"/>
                  </a:lnTo>
                  <a:lnTo>
                    <a:pt x="6069" y="1460"/>
                  </a:lnTo>
                  <a:lnTo>
                    <a:pt x="6090" y="1463"/>
                  </a:lnTo>
                  <a:lnTo>
                    <a:pt x="6112" y="1465"/>
                  </a:lnTo>
                  <a:lnTo>
                    <a:pt x="6133" y="1467"/>
                  </a:lnTo>
                  <a:lnTo>
                    <a:pt x="6155" y="1470"/>
                  </a:lnTo>
                  <a:lnTo>
                    <a:pt x="6176" y="1475"/>
                  </a:lnTo>
                  <a:lnTo>
                    <a:pt x="6197" y="1473"/>
                  </a:lnTo>
                  <a:lnTo>
                    <a:pt x="6219" y="1475"/>
                  </a:lnTo>
                  <a:lnTo>
                    <a:pt x="6240" y="1476"/>
                  </a:lnTo>
                  <a:lnTo>
                    <a:pt x="6262" y="1479"/>
                  </a:lnTo>
                  <a:lnTo>
                    <a:pt x="6283" y="1479"/>
                  </a:lnTo>
                  <a:lnTo>
                    <a:pt x="6305" y="1479"/>
                  </a:lnTo>
                  <a:lnTo>
                    <a:pt x="6326" y="1482"/>
                  </a:lnTo>
                  <a:lnTo>
                    <a:pt x="6348" y="1483"/>
                  </a:lnTo>
                  <a:lnTo>
                    <a:pt x="6369" y="1484"/>
                  </a:lnTo>
                  <a:lnTo>
                    <a:pt x="6390" y="1486"/>
                  </a:lnTo>
                  <a:lnTo>
                    <a:pt x="6412" y="1488"/>
                  </a:lnTo>
                  <a:lnTo>
                    <a:pt x="6433" y="1489"/>
                  </a:lnTo>
                  <a:lnTo>
                    <a:pt x="6455" y="1492"/>
                  </a:lnTo>
                  <a:lnTo>
                    <a:pt x="6476" y="1493"/>
                  </a:lnTo>
                  <a:lnTo>
                    <a:pt x="6498" y="1494"/>
                  </a:lnTo>
                  <a:lnTo>
                    <a:pt x="6519" y="1499"/>
                  </a:lnTo>
                  <a:lnTo>
                    <a:pt x="6541" y="1496"/>
                  </a:lnTo>
                  <a:lnTo>
                    <a:pt x="6562" y="1497"/>
                  </a:lnTo>
                  <a:lnTo>
                    <a:pt x="6583" y="1502"/>
                  </a:lnTo>
                  <a:lnTo>
                    <a:pt x="6605" y="1504"/>
                  </a:lnTo>
                  <a:lnTo>
                    <a:pt x="6626" y="1503"/>
                  </a:lnTo>
                  <a:lnTo>
                    <a:pt x="6648" y="1508"/>
                  </a:lnTo>
                  <a:lnTo>
                    <a:pt x="6669" y="1506"/>
                  </a:lnTo>
                  <a:lnTo>
                    <a:pt x="6691" y="1509"/>
                  </a:lnTo>
                  <a:lnTo>
                    <a:pt x="6712" y="1509"/>
                  </a:lnTo>
                  <a:lnTo>
                    <a:pt x="6734" y="1509"/>
                  </a:lnTo>
                  <a:lnTo>
                    <a:pt x="6755" y="1511"/>
                  </a:lnTo>
                  <a:lnTo>
                    <a:pt x="6776" y="1514"/>
                  </a:lnTo>
                  <a:lnTo>
                    <a:pt x="6798" y="1512"/>
                  </a:lnTo>
                  <a:lnTo>
                    <a:pt x="6819" y="1513"/>
                  </a:lnTo>
                  <a:lnTo>
                    <a:pt x="6841" y="1514"/>
                  </a:lnTo>
                  <a:lnTo>
                    <a:pt x="6862" y="1518"/>
                  </a:lnTo>
                  <a:lnTo>
                    <a:pt x="6884" y="1517"/>
                  </a:lnTo>
                  <a:lnTo>
                    <a:pt x="6905" y="1519"/>
                  </a:lnTo>
                  <a:lnTo>
                    <a:pt x="6927" y="1518"/>
                  </a:lnTo>
                  <a:lnTo>
                    <a:pt x="6948" y="1522"/>
                  </a:lnTo>
                  <a:lnTo>
                    <a:pt x="6969" y="1527"/>
                  </a:lnTo>
                  <a:lnTo>
                    <a:pt x="6991" y="1524"/>
                  </a:lnTo>
                  <a:lnTo>
                    <a:pt x="7012" y="1524"/>
                  </a:lnTo>
                  <a:lnTo>
                    <a:pt x="7034" y="1527"/>
                  </a:lnTo>
                  <a:lnTo>
                    <a:pt x="7055" y="1525"/>
                  </a:lnTo>
                  <a:lnTo>
                    <a:pt x="7077" y="1527"/>
                  </a:lnTo>
                  <a:lnTo>
                    <a:pt x="7098" y="1528"/>
                  </a:lnTo>
                  <a:lnTo>
                    <a:pt x="7120" y="1528"/>
                  </a:lnTo>
                  <a:lnTo>
                    <a:pt x="7141" y="1530"/>
                  </a:lnTo>
                  <a:lnTo>
                    <a:pt x="7162" y="1528"/>
                  </a:lnTo>
                  <a:lnTo>
                    <a:pt x="7184" y="1531"/>
                  </a:lnTo>
                  <a:lnTo>
                    <a:pt x="7205" y="1530"/>
                  </a:lnTo>
                  <a:lnTo>
                    <a:pt x="7227" y="1532"/>
                  </a:lnTo>
                  <a:lnTo>
                    <a:pt x="7248" y="1533"/>
                  </a:lnTo>
                  <a:lnTo>
                    <a:pt x="7270" y="1532"/>
                  </a:lnTo>
                  <a:lnTo>
                    <a:pt x="7291" y="1535"/>
                  </a:lnTo>
                  <a:lnTo>
                    <a:pt x="7313" y="1534"/>
                  </a:lnTo>
                  <a:lnTo>
                    <a:pt x="7334" y="1537"/>
                  </a:lnTo>
                  <a:lnTo>
                    <a:pt x="7355" y="1537"/>
                  </a:lnTo>
                  <a:lnTo>
                    <a:pt x="7377" y="1541"/>
                  </a:lnTo>
                  <a:lnTo>
                    <a:pt x="7398" y="1540"/>
                  </a:lnTo>
                  <a:lnTo>
                    <a:pt x="7420" y="1540"/>
                  </a:lnTo>
                  <a:lnTo>
                    <a:pt x="7441" y="1541"/>
                  </a:lnTo>
                  <a:lnTo>
                    <a:pt x="7463" y="1543"/>
                  </a:lnTo>
                  <a:lnTo>
                    <a:pt x="7484" y="1543"/>
                  </a:lnTo>
                  <a:lnTo>
                    <a:pt x="7506" y="1542"/>
                  </a:lnTo>
                  <a:lnTo>
                    <a:pt x="7527" y="1543"/>
                  </a:lnTo>
                  <a:lnTo>
                    <a:pt x="7549" y="1542"/>
                  </a:lnTo>
                </a:path>
              </a:pathLst>
            </a:custGeom>
            <a:noFill/>
            <a:ln w="9525">
              <a:solidFill>
                <a:srgbClr val="C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35609" tIns="17805" rIns="35609" bIns="17805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</p:grpSp>
      <p:sp>
        <p:nvSpPr>
          <p:cNvPr id="162" name="TextBox 161">
            <a:extLst>
              <a:ext uri="{FF2B5EF4-FFF2-40B4-BE49-F238E27FC236}">
                <a16:creationId xmlns:a16="http://schemas.microsoft.com/office/drawing/2014/main" id="{7EB8E2F9-D8A6-4FA3-8E21-2E1180BCD938}"/>
              </a:ext>
            </a:extLst>
          </p:cNvPr>
          <p:cNvSpPr txBox="1"/>
          <p:nvPr/>
        </p:nvSpPr>
        <p:spPr>
          <a:xfrm>
            <a:off x="5580739" y="4364333"/>
            <a:ext cx="643219" cy="31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80F6EBD2-22A0-44A6-AF63-AF5F7DFF23D8}"/>
              </a:ext>
            </a:extLst>
          </p:cNvPr>
          <p:cNvSpPr txBox="1"/>
          <p:nvPr/>
        </p:nvSpPr>
        <p:spPr>
          <a:xfrm>
            <a:off x="6303514" y="2620006"/>
            <a:ext cx="1374587" cy="31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C8FDE050-EF7B-437F-8FA7-F592FB1E5A02}"/>
              </a:ext>
            </a:extLst>
          </p:cNvPr>
          <p:cNvSpPr txBox="1"/>
          <p:nvPr/>
        </p:nvSpPr>
        <p:spPr>
          <a:xfrm>
            <a:off x="7036545" y="2606378"/>
            <a:ext cx="13745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6BE53E74-D7F1-4954-8E31-B2E2309E95BF}"/>
              </a:ext>
            </a:extLst>
          </p:cNvPr>
          <p:cNvCxnSpPr/>
          <p:nvPr/>
        </p:nvCxnSpPr>
        <p:spPr>
          <a:xfrm>
            <a:off x="6554015" y="4610426"/>
            <a:ext cx="680308" cy="0"/>
          </a:xfrm>
          <a:prstGeom prst="line">
            <a:avLst/>
          </a:prstGeom>
          <a:ln w="25400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41ABE518-2C19-43D1-A702-4E0B35C0181C}"/>
              </a:ext>
            </a:extLst>
          </p:cNvPr>
          <p:cNvSpPr txBox="1"/>
          <p:nvPr/>
        </p:nvSpPr>
        <p:spPr>
          <a:xfrm>
            <a:off x="6550841" y="4551283"/>
            <a:ext cx="687293" cy="31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C652F1D4-8F6D-4803-B233-44EE963D0685}"/>
              </a:ext>
            </a:extLst>
          </p:cNvPr>
          <p:cNvSpPr txBox="1"/>
          <p:nvPr/>
        </p:nvSpPr>
        <p:spPr>
          <a:xfrm>
            <a:off x="5802644" y="2392295"/>
            <a:ext cx="2091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 of 10µM SNP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37840E5A-37F7-4310-8DBC-E07E67EE5658}"/>
              </a:ext>
            </a:extLst>
          </p:cNvPr>
          <p:cNvSpPr txBox="1"/>
          <p:nvPr/>
        </p:nvSpPr>
        <p:spPr>
          <a:xfrm rot="16200000">
            <a:off x="4168238" y="3493419"/>
            <a:ext cx="27227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% Relaxation of MO-induced</a:t>
            </a: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re-contracted tone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BC990B7-F8A4-4D2B-8BFF-5BC2EF7A4482}"/>
              </a:ext>
            </a:extLst>
          </p:cNvPr>
          <p:cNvSpPr txBox="1"/>
          <p:nvPr/>
        </p:nvSpPr>
        <p:spPr>
          <a:xfrm>
            <a:off x="5704645" y="3089023"/>
            <a:ext cx="449685" cy="529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2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17B54B89-DFD3-4257-B462-2188E01F01E7}"/>
              </a:ext>
            </a:extLst>
          </p:cNvPr>
          <p:cNvSpPr txBox="1"/>
          <p:nvPr/>
        </p:nvSpPr>
        <p:spPr>
          <a:xfrm>
            <a:off x="5791882" y="3409687"/>
            <a:ext cx="449684" cy="31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C613E9DB-82B0-45F3-A5C3-D6B310C4EA84}"/>
              </a:ext>
            </a:extLst>
          </p:cNvPr>
          <p:cNvSpPr txBox="1"/>
          <p:nvPr/>
        </p:nvSpPr>
        <p:spPr>
          <a:xfrm>
            <a:off x="5702554" y="3726440"/>
            <a:ext cx="494644" cy="31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6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43137F7C-DE1C-4644-B16A-F0F1A1C1B3E6}"/>
              </a:ext>
            </a:extLst>
          </p:cNvPr>
          <p:cNvSpPr txBox="1"/>
          <p:nvPr/>
        </p:nvSpPr>
        <p:spPr>
          <a:xfrm>
            <a:off x="5707357" y="4047133"/>
            <a:ext cx="460777" cy="529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80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A88BA14-7B54-4023-BA0A-862EB553F40F}"/>
              </a:ext>
            </a:extLst>
          </p:cNvPr>
          <p:cNvSpPr txBox="1"/>
          <p:nvPr/>
        </p:nvSpPr>
        <p:spPr>
          <a:xfrm>
            <a:off x="5747512" y="2774353"/>
            <a:ext cx="449687" cy="317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9" name="Text Box 19">
            <a:extLst>
              <a:ext uri="{FF2B5EF4-FFF2-40B4-BE49-F238E27FC236}">
                <a16:creationId xmlns:a16="http://schemas.microsoft.com/office/drawing/2014/main" id="{E54322A0-A063-4F49-939C-983C4603C5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6842" y="2673201"/>
            <a:ext cx="349483" cy="3177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/>
              <a:t>D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99D02CE-C45A-475C-B592-5A04629B37AD}"/>
              </a:ext>
            </a:extLst>
          </p:cNvPr>
          <p:cNvSpPr/>
          <p:nvPr/>
        </p:nvSpPr>
        <p:spPr>
          <a:xfrm>
            <a:off x="89106" y="4553658"/>
            <a:ext cx="9580911" cy="2552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data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Figure S1. Properties of pre-contracted tone and vasorelaxation in segments of mesenteric artery from WT and TRPC1</a:t>
            </a:r>
            <a:r>
              <a:rPr lang="en-GB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mice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A &amp; B, Original traces and mean data showing that contractions induced by 60mM KCl and 10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M methoxamine were similar in WT and TRPC1</a:t>
            </a:r>
            <a:r>
              <a:rPr lang="en-GB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 vessels. Mean KCl-induced pre-contracted tone in WT mice was</a:t>
            </a:r>
            <a:r>
              <a:rPr lang="pt-BR" sz="1200" dirty="0">
                <a:latin typeface="Arial" panose="020B0604020202020204" pitchFamily="34" charset="0"/>
                <a:ea typeface="Times New Roman" panose="02020603050405020304" pitchFamily="18" charset="0"/>
              </a:rPr>
              <a:t> 2.3±0.3mN  vs. 2.3±0.3mN in TRPC1-/- mice. N=6 animals, n=3 segments per animal. Mean methoxaimne-induced precontracted tone in WT mice was 4.2±0.3mN vs. 4.1±0.3mN in TRPC1-/-.N=6 animals, n=3 segments per animal. 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C &amp; D, Original traces and mean data showing that SNP-induced relaxations of pre-contracted tone were unaffected in WT and TRPC1</a:t>
            </a:r>
            <a:r>
              <a:rPr lang="en-GB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 vessels (</a:t>
            </a:r>
            <a:r>
              <a:rPr lang="pt-BR" sz="1200" dirty="0">
                <a:latin typeface="Arial" panose="020B0604020202020204" pitchFamily="34" charset="0"/>
                <a:ea typeface="Times New Roman" panose="02020603050405020304" pitchFamily="18" charset="0"/>
              </a:rPr>
              <a:t>95.9±3.3% in WT mice vs. 91.1±4.3% in TRPC1-/- mice. N=7 animals, n=3 segments per animal 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0865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A4DB6BA-13E9-4CFE-A47F-9593FA6B08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6990317"/>
              </p:ext>
            </p:extLst>
          </p:nvPr>
        </p:nvGraphicFramePr>
        <p:xfrm>
          <a:off x="1821614" y="1018902"/>
          <a:ext cx="6305839" cy="280400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46910">
                  <a:extLst>
                    <a:ext uri="{9D8B030D-6E8A-4147-A177-3AD203B41FA5}">
                      <a16:colId xmlns:a16="http://schemas.microsoft.com/office/drawing/2014/main" val="745554865"/>
                    </a:ext>
                  </a:extLst>
                </a:gridCol>
                <a:gridCol w="982413">
                  <a:extLst>
                    <a:ext uri="{9D8B030D-6E8A-4147-A177-3AD203B41FA5}">
                      <a16:colId xmlns:a16="http://schemas.microsoft.com/office/drawing/2014/main" val="410983641"/>
                    </a:ext>
                  </a:extLst>
                </a:gridCol>
                <a:gridCol w="989970">
                  <a:extLst>
                    <a:ext uri="{9D8B030D-6E8A-4147-A177-3AD203B41FA5}">
                      <a16:colId xmlns:a16="http://schemas.microsoft.com/office/drawing/2014/main" val="1740380108"/>
                    </a:ext>
                  </a:extLst>
                </a:gridCol>
                <a:gridCol w="441587">
                  <a:extLst>
                    <a:ext uri="{9D8B030D-6E8A-4147-A177-3AD203B41FA5}">
                      <a16:colId xmlns:a16="http://schemas.microsoft.com/office/drawing/2014/main" val="398811498"/>
                    </a:ext>
                  </a:extLst>
                </a:gridCol>
                <a:gridCol w="1080655">
                  <a:extLst>
                    <a:ext uri="{9D8B030D-6E8A-4147-A177-3AD203B41FA5}">
                      <a16:colId xmlns:a16="http://schemas.microsoft.com/office/drawing/2014/main" val="1576193107"/>
                    </a:ext>
                  </a:extLst>
                </a:gridCol>
                <a:gridCol w="1027755">
                  <a:extLst>
                    <a:ext uri="{9D8B030D-6E8A-4147-A177-3AD203B41FA5}">
                      <a16:colId xmlns:a16="http://schemas.microsoft.com/office/drawing/2014/main" val="2589557363"/>
                    </a:ext>
                  </a:extLst>
                </a:gridCol>
                <a:gridCol w="536549">
                  <a:extLst>
                    <a:ext uri="{9D8B030D-6E8A-4147-A177-3AD203B41FA5}">
                      <a16:colId xmlns:a16="http://schemas.microsoft.com/office/drawing/2014/main" val="3994326310"/>
                    </a:ext>
                  </a:extLst>
                </a:gridCol>
              </a:tblGrid>
              <a:tr h="39233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dirty="0"/>
                        <a:t>Condition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dirty="0"/>
                        <a:t>Wild-typ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dirty="0"/>
                        <a:t>TRPC1</a:t>
                      </a:r>
                      <a:r>
                        <a:rPr lang="en-GB" sz="1200" b="1" baseline="30000" dirty="0"/>
                        <a:t>-/-</a:t>
                      </a:r>
                      <a:r>
                        <a:rPr lang="en-GB" sz="1200" b="1" dirty="0"/>
                        <a:t> 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2625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EC</a:t>
                      </a:r>
                      <a:r>
                        <a:rPr lang="en-GB" sz="1200" b="1" baseline="-25000" dirty="0"/>
                        <a:t>50</a:t>
                      </a:r>
                      <a:r>
                        <a:rPr lang="en-GB" sz="1200" b="1" dirty="0"/>
                        <a:t> (mM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err="1"/>
                        <a:t>E</a:t>
                      </a:r>
                      <a:r>
                        <a:rPr lang="en-GB" sz="1200" b="1" baseline="-25000" dirty="0" err="1"/>
                        <a:t>max</a:t>
                      </a:r>
                      <a:r>
                        <a:rPr lang="en-GB" sz="1200" b="1" dirty="0"/>
                        <a:t> (%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N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EC</a:t>
                      </a:r>
                      <a:r>
                        <a:rPr lang="en-GB" sz="1200" b="1" baseline="-25000" dirty="0"/>
                        <a:t>50</a:t>
                      </a:r>
                      <a:r>
                        <a:rPr lang="en-GB" sz="1200" b="1" dirty="0"/>
                        <a:t> (mM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err="1"/>
                        <a:t>E</a:t>
                      </a:r>
                      <a:r>
                        <a:rPr lang="en-GB" sz="1200" b="1" baseline="-25000" dirty="0" err="1"/>
                        <a:t>max</a:t>
                      </a:r>
                      <a:r>
                        <a:rPr lang="en-GB" sz="1200" b="1" dirty="0"/>
                        <a:t> (%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N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9429615"/>
                  </a:ext>
                </a:extLst>
              </a:tr>
              <a:tr h="302625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Control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2.4±0.1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71.4±2.3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20</a:t>
                      </a:r>
                      <a:endParaRPr lang="en-GB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.7±0.2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4.3±8.6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3532424"/>
                  </a:ext>
                </a:extLst>
              </a:tr>
              <a:tr h="373099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+ Calhex-231 (3µM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.4±0.1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28.6±2.5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.3±0.1</a:t>
                      </a:r>
                      <a:r>
                        <a:rPr lang="en-GB" sz="1200" baseline="30000" dirty="0"/>
                        <a:t>#</a:t>
                      </a:r>
                      <a:endParaRPr lang="en-US" sz="12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8.9±5.9</a:t>
                      </a:r>
                      <a:r>
                        <a:rPr lang="en-GB" sz="1200" baseline="30000" dirty="0"/>
                        <a:t>#</a:t>
                      </a:r>
                      <a:endParaRPr lang="en-US" sz="12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7213564"/>
                  </a:ext>
                </a:extLst>
              </a:tr>
              <a:tr h="373099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+ RN1734 (30µM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.5±0.2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20.9±5.9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.1±0.1</a:t>
                      </a:r>
                      <a:r>
                        <a:rPr lang="en-GB" sz="1200" baseline="30000" dirty="0"/>
                        <a:t>#</a:t>
                      </a:r>
                      <a:endParaRPr lang="en-US" sz="12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16.3±5.7</a:t>
                      </a:r>
                      <a:r>
                        <a:rPr lang="en-GB" sz="1200" baseline="30000" dirty="0"/>
                        <a:t>#</a:t>
                      </a:r>
                      <a:endParaRPr lang="en-US" sz="12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961602"/>
                  </a:ext>
                </a:extLst>
              </a:tr>
              <a:tr h="426634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+ T1E3 (1µg/ml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.8±0.1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9.3±6.8*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.4±0.2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1.4±4.8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7519091"/>
                  </a:ext>
                </a:extLst>
              </a:tr>
              <a:tr h="400522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+ T1E3 + </a:t>
                      </a:r>
                      <a:r>
                        <a:rPr lang="en-GB" sz="1200" b="1" dirty="0" err="1"/>
                        <a:t>AgP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2.2±0.2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71.3±2.1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7189537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70C65B12-0165-499B-86B1-470502F29245}"/>
              </a:ext>
            </a:extLst>
          </p:cNvPr>
          <p:cNvSpPr/>
          <p:nvPr/>
        </p:nvSpPr>
        <p:spPr>
          <a:xfrm>
            <a:off x="1610139" y="4007754"/>
            <a:ext cx="6728791" cy="17209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data 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Figure S2. Effect of various inhibitors tested on [Ca</a:t>
            </a:r>
            <a:r>
              <a:rPr lang="en-GB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2+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]</a:t>
            </a:r>
            <a:r>
              <a:rPr lang="en-GB" sz="1200" b="1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o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-induced vasorelaxation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Table showing mean EC</a:t>
            </a:r>
            <a:r>
              <a:rPr lang="en-GB" sz="12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50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GB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Arial" panose="020B0604020202020204" pitchFamily="34" charset="0"/>
                <a:ea typeface="Times New Roman" panose="02020603050405020304" pitchFamily="18" charset="0"/>
              </a:rPr>
              <a:t>max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 values ± SEM for [Ca</a:t>
            </a:r>
            <a:r>
              <a:rPr lang="en-GB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2+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]</a:t>
            </a:r>
            <a:r>
              <a:rPr lang="en-GB" sz="12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o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-induced relaxations under different experimental conditions. Data are compared using unpaired Student’s </a:t>
            </a:r>
            <a:r>
              <a:rPr lang="en-GB" sz="1200" i="1" dirty="0">
                <a:latin typeface="Arial" panose="020B0604020202020204" pitchFamily="34" charset="0"/>
                <a:ea typeface="Times New Roman" panose="02020603050405020304" pitchFamily="18" charset="0"/>
              </a:rPr>
              <a:t>t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-test, with * (vs WT control) and </a:t>
            </a:r>
            <a:r>
              <a:rPr lang="en-GB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#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 (vs C1</a:t>
            </a:r>
            <a:r>
              <a:rPr lang="en-GB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 control) representing p&lt;0.05. N=number of animals used, with at least n=3 vessel segments used per animal.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3555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</TotalTime>
  <Words>341</Words>
  <Application>Microsoft Office PowerPoint</Application>
  <PresentationFormat>A4 Paper (210x297 mm)</PresentationFormat>
  <Paragraphs>10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Greenberg</dc:creator>
  <cp:lastModifiedBy>Harry Greenberg</cp:lastModifiedBy>
  <cp:revision>114</cp:revision>
  <cp:lastPrinted>2019-04-25T11:15:04Z</cp:lastPrinted>
  <dcterms:created xsi:type="dcterms:W3CDTF">2017-03-22T12:23:33Z</dcterms:created>
  <dcterms:modified xsi:type="dcterms:W3CDTF">2019-07-13T21:29:27Z</dcterms:modified>
</cp:coreProperties>
</file>